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Ex1.xml" ContentType="application/vnd.ms-office.chartex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34" r:id="rId1"/>
  </p:sldMasterIdLst>
  <p:notesMasterIdLst>
    <p:notesMasterId r:id="rId4"/>
  </p:notesMasterIdLst>
  <p:sldIdLst>
    <p:sldId id="343" r:id="rId2"/>
    <p:sldId id="341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50021"/>
    <a:srgbClr val="0033CC"/>
    <a:srgbClr val="001848"/>
    <a:srgbClr val="009900"/>
    <a:srgbClr val="FF9900"/>
    <a:srgbClr val="990099"/>
    <a:srgbClr val="ECF3FA"/>
    <a:srgbClr val="0066FF"/>
    <a:srgbClr val="EAEFF7"/>
    <a:srgbClr val="D2DEE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B301B821-A1FF-4177-AEE7-76D212191A09}" styleName="보통 스타일 1 - 강조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1">
              <a:tint val="20000"/>
            </a:schemeClr>
          </a:solidFill>
        </a:fill>
      </a:tcStyle>
    </a:band1H>
    <a:band1V>
      <a:tcStyle>
        <a:tcBdr/>
        <a:fill>
          <a:solidFill>
            <a:schemeClr val="accent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Row>
  </a:tblStyle>
  <a:tblStyle styleId="{EB9631B5-78F2-41C9-869B-9F39066F8104}" styleName="보통 스타일 3 - 강조 4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4"/>
          </a:solidFill>
        </a:fill>
      </a:tcStyle>
    </a:firstRow>
  </a:tblStyle>
  <a:tblStyle styleId="{22838BEF-8BB2-4498-84A7-C5851F593DF1}" styleName="보통 스타일 4 - 강조 5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5"/>
              </a:solidFill>
            </a:ln>
          </a:left>
          <a:right>
            <a:ln w="12700" cmpd="sng">
              <a:solidFill>
                <a:schemeClr val="accent5"/>
              </a:solidFill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 w="12700" cmpd="sng">
              <a:solidFill>
                <a:schemeClr val="accent5"/>
              </a:solidFill>
            </a:ln>
          </a:insideH>
          <a:insideV>
            <a:ln w="12700" cmpd="sng">
              <a:solidFill>
                <a:schemeClr val="accent5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5"/>
              </a:solidFill>
            </a:ln>
          </a:top>
        </a:tcBdr>
        <a:fill>
          <a:solidFill>
            <a:schemeClr val="accent5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5">
              <a:tint val="20000"/>
            </a:schemeClr>
          </a:solidFill>
        </a:fill>
      </a:tcStyle>
    </a:firstRow>
  </a:tblStyle>
  <a:tblStyle styleId="{0660B408-B3CF-4A94-85FC-2B1E0A45F4A2}" styleName="어두운 스타일 2 - 강조 1/강조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Row>
  </a:tblStyle>
  <a:tblStyle styleId="{F5AB1C69-6EDB-4FF4-983F-18BD219EF322}" styleName="보통 스타일 2 - 강조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073A0DAA-6AF3-43AB-8588-CEC1D06C72B9}" styleName="보통 스타일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6E25E649-3F16-4E02-A733-19D2CDBF48F0}" styleName="보통 스타일 3 - 강조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DF18680-E054-41AD-8BC1-D1AEF772440D}" styleName="보통 스타일 2 - 강조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EB344D84-9AFB-497E-A393-DC336BA19D2E}" styleName="보통 스타일 3 - 강조 3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2D5ABB26-0587-4C30-8999-92F81FD0307C}" styleName="스타일 없음, 눈금 없음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117" autoAdjust="0"/>
    <p:restoredTop sz="94380" autoAdjust="0"/>
  </p:normalViewPr>
  <p:slideViewPr>
    <p:cSldViewPr snapToGrid="0">
      <p:cViewPr varScale="1">
        <p:scale>
          <a:sx n="106" d="100"/>
          <a:sy n="106" d="100"/>
        </p:scale>
        <p:origin x="4356" y="6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charts/_rels/chartEx1.xml.rels><?xml version="1.0" encoding="UTF-8" standalone="yes"?>
<Relationships xmlns="http://schemas.openxmlformats.org/package/2006/relationships"><Relationship Id="rId3" Type="http://schemas.microsoft.com/office/2011/relationships/chartColorStyle" Target="colors1.xml"/><Relationship Id="rId2" Type="http://schemas.microsoft.com/office/2011/relationships/chartStyle" Target="style1.xml"/><Relationship Id="rId1" Type="http://schemas.openxmlformats.org/officeDocument/2006/relationships/oleObject" Target="file:///E:\&#50672;&#44396;-&#49436;&#50872;&#45824;\vita-D\vitaD&#45436;&#47928;_2022\FGF&#45436;&#47928;\FGF&#45453;&#46020;&#48320;&#54868;.xlsx" TargetMode="External"/></Relationships>
</file>

<file path=ppt/charts/chartEx1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numDim type="val">
        <cx:f>Sheet2!$I$2:$I$401</cx:f>
        <cx:lvl ptCount="400" formatCode="G/표준">
          <cx:pt idx="0">9.5025919881423331</cx:pt>
          <cx:pt idx="1">10.723359890763776</cx:pt>
          <cx:pt idx="2">10.955605539524452</cx:pt>
          <cx:pt idx="3">9.3459022018671121</cx:pt>
          <cx:pt idx="4">9.3701436173395347</cx:pt>
          <cx:pt idx="5">9.3917281596100466</cx:pt>
          <cx:pt idx="6">9.8137050668416208</cx:pt>
          <cx:pt idx="7">10.798460670100587</cx:pt>
          <cx:pt idx="8">9.4308564745681061</cx:pt>
          <cx:pt idx="9">9.4458866900074359</cx:pt>
          <cx:pt idx="10">9.8000695933376392</cx:pt>
          <cx:pt idx="11">10.94750020971027</cx:pt>
          <cx:pt idx="12">11.596635899840107</cx:pt>
          <cx:pt idx="13">9.3690691278318177</cx:pt>
          <cx:pt idx="14">10.949756873295126</cx:pt>
          <cx:pt idx="15">11.646942239777758</cx:pt>
          <cx:pt idx="16">8.7556036088004454</cx:pt>
          <cx:pt idx="17">9.7963365460168994</cx:pt>
          <cx:pt idx="18">6.1959348331565707</cx:pt>
          <cx:pt idx="19">11.315549557948783</cx:pt>
          <cx:pt idx="20">9.4458866900074359</cx:pt>
          <cx:pt idx="21">9.8235240083957436</cx:pt>
          <cx:pt idx="22">10.192785818243699</cx:pt>
          <cx:pt idx="23">4.4904325085176682</cx:pt>
          <cx:pt idx="24">6.5761491834684067</cx:pt>
          <cx:pt idx="25">11.343524082102348</cx:pt>
          <cx:pt idx="26">8.4138306784210837</cx:pt>
          <cx:pt idx="27">6.4768185049003035</cx:pt>
          <cx:pt idx="28">9.2878383059965657</cx:pt>
          <cx:pt idx="29">6.5527931530470793</cx:pt>
          <cx:pt idx="30">4.5036910170382374</cx:pt>
          <cx:pt idx="31">9.1839347930964106</cx:pt>
          <cx:pt idx="32">8.3788502417944919</cx:pt>
          <cx:pt idx="33">6.2931789542222187</cx:pt>
          <cx:pt idx="34">4.5168852711205201</cx:pt>
          <cx:pt idx="35">11.361507049107946</cx:pt>
          <cx:pt idx="36">7.4954030453494127</cx:pt>
          <cx:pt idx="37">5.673701202617746</cx:pt>
          <cx:pt idx="38">12.235547949140173</cx:pt>
          <cx:pt idx="39">9.6368230553068166</cx:pt>
          <cx:pt idx="40">9.4971420570006568</cx:pt>
          <cx:pt idx="41">10.74138421698227</cx:pt>
          <cx:pt idx="42">7.6403154618989175</cx:pt>
          <cx:pt idx="43">3.434954478460289</cx:pt>
          <cx:pt idx="44">11.873824076653154</cx:pt>
          <cx:pt idx="45">6.3653701863083807</cx:pt>
          <cx:pt idx="46">10.624779915288217</cx:pt>
          <cx:pt idx="47">8.4574856489539521</cx:pt>
          <cx:pt idx="48">10.120862497387471</cx:pt>
          <cx:pt idx="49">8.3961548630391807</cx:pt>
          <cx:pt idx="50">8.2933994287604413</cx:pt>
          <cx:pt idx="51">4.0479515226523901</cx:pt>
          <cx:pt idx="52">4.9836751125134722</cx:pt>
          <cx:pt idx="53">5.7615795733824182</cx:pt>
          <cx:pt idx="54">10.09907900682841</cx:pt>
          <cx:pt idx="55">7.9442084357418601</cx:pt>
          <cx:pt idx="56">7.9658927350845286</cx:pt>
          <cx:pt idx="57">9.0178472598607318</cx:pt>
          <cx:pt idx="58">7.7244466456335372</cx:pt>
          <cx:pt idx="59">7.8024341478798318</cx:pt>
          <cx:pt idx="60">6.1568730477709535</cx:pt>
          <cx:pt idx="61">8.0945005376414478</cx:pt>
          <cx:pt idx="62">9.8183326330805372</cx:pt>
          <cx:pt idx="63">9.3253997017109693</cx:pt>
          <cx:pt idx="64">8.1846253228207377</cx:pt>
          <cx:pt idx="65">9.4463132741023177</cx:pt>
          <cx:pt idx="66">5.5126219691950418</cx:pt>
          <cx:pt idx="67">6.4397336842077113</cx:pt>
          <cx:pt idx="68">8.6659579646813487</cx:pt>
          <cx:pt idx="69">7.2295633779132453</cx:pt>
          <cx:pt idx="70">7.4074875989501727</cx:pt>
          <cx:pt idx="71">7.1451724754112922</cx:pt>
          <cx:pt idx="72">4.5796472287570058</cx:pt>
          <cx:pt idx="73">11.913691549941925</cx:pt>
          <cx:pt idx="74">6.1883257228279973</cx:pt>
          <cx:pt idx="75">6.7002389835536267</cx:pt>
          <cx:pt idx="76">8.6089698629996683</cx:pt>
          <cx:pt idx="77">5.1402004984508993</cx:pt>
          <cx:pt idx="78">12.521641492095258</cx:pt>
          <cx:pt idx="79">5.5043554499593075</cx:pt>
          <cx:pt idx="80">10.589474157255212</cx:pt>
          <cx:pt idx="81">5.0622152140694352</cx:pt>
          <cx:pt idx="82">6.0862518629700491</cx:pt>
          <cx:pt idx="83">5.8726528575685544</cx:pt>
          <cx:pt idx="84">8.6589704928946105</cx:pt>
          <cx:pt idx="85">10.092859198942564</cx:pt>
          <cx:pt idx="86">10.373653668580168</cx:pt>
          <cx:pt idx="87">9.3753631641918087</cx:pt>
          <cx:pt idx="88">6.3066401838686854</cx:pt>
          <cx:pt idx="89">7.008685997560578</cx:pt>
          <cx:pt idx="90">11.975228268827125</cx:pt>
          <cx:pt idx="91">8.0864718118919079</cx:pt>
          <cx:pt idx="92">9.6038543489645924</cx:pt>
          <cx:pt idx="93">9.7040239060749158</cx:pt>
          <cx:pt idx="94">4.1526134703460764</cx:pt>
          <cx:pt idx="95">7.8245258956931432</cx:pt>
          <cx:pt idx="96">8.6757683544801907</cx:pt>
          <cx:pt idx="97">6.6694980898578793</cx:pt>
          <cx:pt idx="98">8.9671981741552838</cx:pt>
          <cx:pt idx="99">9.5801368508048874</cx:pt>
          <cx:pt idx="100">9.5678749463267962</cx:pt>
          <cx:pt idx="101">8.7559895951381712</cx:pt>
          <cx:pt idx="102">11.401274092187757</cx:pt>
          <cx:pt idx="103">11.410154925759278</cx:pt>
          <cx:pt idx="104">11.918917101104846</cx:pt>
          <cx:pt idx="105">5.5143557357321997</cx:pt>
          <cx:pt idx="106">6.131226489483141</cx:pt>
          <cx:pt idx="107">12.230385673892444</cx:pt>
          <cx:pt idx="108">9.7804947194216822</cx:pt>
          <cx:pt idx="109">2.2823823856765264</cx:pt>
          <cx:pt idx="110">8.9980131130958227</cx:pt>
          <cx:pt idx="111">9.8231664727873476</cx:pt>
          <cx:pt idx="112">10.685547218500055</cx:pt>
          <cx:pt idx="113">8.8635308896599074</cx:pt>
          <cx:pt idx="114">8.8942862594686254</cx:pt>
          <cx:pt idx="115">9.0325286306600567</cx:pt>
          <cx:pt idx="116">8.8812250070885312</cx:pt>
          <cx:pt idx="117">10.773248363964433</cx:pt>
          <cx:pt idx="118">8.8317995308058777</cx:pt>
          <cx:pt idx="119">8.7888373411702467</cx:pt>
          <cx:pt idx="120">8.8477910648448503</cx:pt>
          <cx:pt idx="121">8.8225285241053371</cx:pt>
          <cx:pt idx="122">8.6302003964825769</cx:pt>
          <cx:pt idx="123">8.7159128940198283</cx:pt>
          <cx:pt idx="124">8.6969782005581955</cx:pt>
          <cx:pt idx="125">8.7496056533507627</cx:pt>
          <cx:pt idx="126">8.8341039145281481</cx:pt>
          <cx:pt idx="127">8.68169016329764</cx:pt>
          <cx:pt idx="128">8.706159290928861</cx:pt>
          <cx:pt idx="129">8.7401767299290825</cx:pt>
          <cx:pt idx="130">8.7773396136734974</cx:pt>
          <cx:pt idx="131">9.0594942261572253</cx:pt>
          <cx:pt idx="132">3.7355244619369801</cx:pt>
          <cx:pt idx="133">4.4791533454046046</cx:pt>
          <cx:pt idx="134">4.8460750668809434</cx:pt>
          <cx:pt idx="135">9.4833706288955995</cx:pt>
          <cx:pt idx="136">5.1550241967215609</cx:pt>
          <cx:pt idx="137">6.5336144041159985</cx:pt>
          <cx:pt idx="138">5.2238093143729749</cx:pt>
          <cx:pt idx="139">3.4291367503513968</cx:pt>
          <cx:pt idx="140">9.1352934976532723</cx:pt>
          <cx:pt idx="141">5.2963654628227914</cx:pt>
          <cx:pt idx="142">6.3134574624643607</cx:pt>
          <cx:pt idx="143">8.9885209436241045</cx:pt>
          <cx:pt idx="144">6.2108811620145579</cx:pt>
          <cx:pt idx="145">9.5839638742281892</cx:pt>
          <cx:pt idx="146">5.7847170921522002</cx:pt>
          <cx:pt idx="147">7.7612382577419359</cx:pt>
          <cx:pt idx="148">3.9201895680945396</cx:pt>
          <cx:pt idx="149">4.5956247731445599</cx:pt>
          <cx:pt idx="150">5.117514655723352</cx:pt>
          <cx:pt idx="151">9.3833083198430227</cx:pt>
          <cx:pt idx="152">7.5769990354605232</cx:pt>
          <cx:pt idx="153">4.8922270630459543</cx:pt>
          <cx:pt idx="154">7.5607312948528058</cx:pt>
          <cx:pt idx="155">6.3972629330062665</cx:pt>
          <cx:pt idx="156">8.2303107991350206</cx:pt>
          <cx:pt idx="157">10.028771276455251</cx:pt>
          <cx:pt idx="158">7.3319767155727451</cx:pt>
          <cx:pt idx="159">9.9089525919671857</cx:pt>
          <cx:pt idx="160">10.455819736453845</cx:pt>
          <cx:pt idx="161">7.6688414425502751</cx:pt>
          <cx:pt idx="162">9.5444240439610368</cx:pt>
          <cx:pt idx="163">10.383651886544493</cx:pt>
          <cx:pt idx="164">5.7245976610367864</cx:pt>
          <cx:pt idx="165">8.2665242690372764</cx:pt>
          <cx:pt idx="166">7.7933393500771304</cx:pt>
          <cx:pt idx="167">8.1051867352646507</cx:pt>
          <cx:pt idx="168">7.5899780043838563</cx:pt>
          <cx:pt idx="169">9.4592920110679</cx:pt>
          <cx:pt idx="170">10.729490272383172</cx:pt>
          <cx:pt idx="171">8.3052862720280149</cx:pt>
          <cx:pt idx="172">12.141226877197017</cx:pt>
          <cx:pt idx="173">6.9931987607996042</cx:pt>
          <cx:pt idx="174">5.6319283708882173</cx:pt>
          <cx:pt idx="175">5.541655625147766</cx:pt>
          <cx:pt idx="176">6.4828014942901104</cx:pt>
          <cx:pt idx="177">8.4255492826194391</cx:pt>
          <cx:pt idx="178">11.226669042463126</cx:pt>
          <cx:pt idx="179">7.8710822568577212</cx:pt>
          <cx:pt idx="180">7.5045292148844931</cx:pt>
          <cx:pt idx="181">6.8887763123843344</cx:pt>
          <cx:pt idx="182">6.7694123293603923</cx:pt>
          <cx:pt idx="183">8.2795956831318769</cx:pt>
          <cx:pt idx="184">9.4366469157515276</cx:pt>
          <cx:pt idx="185">7.0524182352226985</cx:pt>
          <cx:pt idx="186">7.7009287736092071</cx:pt>
          <cx:pt idx="187">7.3298808279834091</cx:pt>
          <cx:pt idx="188">5.3607286266694336</cx:pt>
          <cx:pt idx="189">10.748166271679739</cx:pt>
          <cx:pt idx="190">5.3162063993837769</cx:pt>
          <cx:pt idx="191">5.9816414581592197</cx:pt>
          <cx:pt idx="192">11.837056142601167</cx:pt>
          <cx:pt idx="193">10.828381173217551</cx:pt>
          <cx:pt idx="194">9.1384361236845084</cx:pt>
          <cx:pt idx="195">4.9199809258281251</cx:pt>
          <cx:pt idx="196">4.478472532942134</cx:pt>
          <cx:pt idx="197">5.3935820907738181</cx:pt>
          <cx:pt idx="198">6.4868008279778397</cx:pt>
          <cx:pt idx="199">3.7184382563554808</cx:pt>
          <cx:pt idx="200">5.9413810469399948</cx:pt>
          <cx:pt idx="201">5.9283649901646651</cx:pt>
          <cx:pt idx="202">6.8227527919121904</cx:pt>
          <cx:pt idx="203">5.8654477065244945</cx:pt>
          <cx:pt idx="204">6.9006198824811253</cx:pt>
          <cx:pt idx="205">5.2836604772044033</cx:pt>
          <cx:pt idx="206">5.1835796890776136</cx:pt>
          <cx:pt idx="207">5.0839477117851883</cx:pt>
          <cx:pt idx="208">5.4417681489529981</cx:pt>
          <cx:pt idx="209">4.1159429617745964</cx:pt>
          <cx:pt idx="210">5.6951789031820335</cx:pt>
          <cx:pt idx="211">6.5634887455949817</cx:pt>
          <cx:pt idx="212">7.8033533876312031</cx:pt>
          <cx:pt idx="213">4.9646611611863047</cx:pt>
          <cx:pt idx="214">6.5613135113234335</cx:pt>
          <cx:pt idx="215">8.9773989781818617</cx:pt>
          <cx:pt idx="216">11.22914776054416</cx:pt>
          <cx:pt idx="217">5.05248076468615</cx:pt>
          <cx:pt idx="218">11.985603016098356</cx:pt>
          <cx:pt idx="219">8.8879840355903799</cx:pt>
          <cx:pt idx="220">8.3735999188600374</cx:pt>
          <cx:pt idx="221">9.3287987351031845</cx:pt>
          <cx:pt idx="222">7.098540914188221</cx:pt>
          <cx:pt idx="223">7.6156925450147179</cx:pt>
          <cx:pt idx="224">7.9871167880581098</cx:pt>
          <cx:pt idx="225">8.3494370421815862</cx:pt>
          <cx:pt idx="226">10.614779123532054</cx:pt>
          <cx:pt idx="227">9.0277627824086348</cx:pt>
          <cx:pt idx="228">4.3588859422322388</cx:pt>
          <cx:pt idx="229">4.382276603429089</cx:pt>
          <cx:pt idx="230">8.2741020022923308</cx:pt>
          <cx:pt idx="231">8.2108310613510938</cx:pt>
          <cx:pt idx="232">7.6863459413595496</cx:pt>
          <cx:pt idx="233">8.4754124040676704</cx:pt>
          <cx:pt idx="234">8.1579435071050366</cx:pt>
          <cx:pt idx="235">7.5152356327849903</cx:pt>
          <cx:pt idx="236">10.392319069467822</cx:pt>
          <cx:pt idx="237">7.6378128135621797</cx:pt>
          <cx:pt idx="238">7.8912559605490227</cx:pt>
          <cx:pt idx="239">7.3802557884264601</cx:pt>
          <cx:pt idx="240">5.8449926432077248</cx:pt>
          <cx:pt idx="241">5.0587903359833026</cx:pt>
          <cx:pt idx="242">8.1299412127274309</cx:pt>
          <cx:pt idx="243">6.8014498726112063</cx:pt>
          <cx:pt idx="244">7.8317562107261898</cx:pt>
          <cx:pt idx="245">9.3071585051561971</cx:pt>
          <cx:pt idx="246">7.364040236086935</cx:pt>
          <cx:pt idx="247">11.076108998952167</cx:pt>
          <cx:pt idx="248">5.6315701405422764</cx:pt>
          <cx:pt idx="249">7.5196652887814599</cx:pt>
          <cx:pt idx="250">10.596179629552164</cx:pt>
          <cx:pt idx="251">1.3083328196501789</cx:pt>
          <cx:pt idx="252">7.6015672385275597</cx:pt>
          <cx:pt idx="253">7.5536116707473848</cx:pt>
          <cx:pt idx="254">7.2513166141754857</cx:pt>
          <cx:pt idx="255">7.676116605374335</cx:pt>
          <cx:pt idx="256">7.6377067940641306</cx:pt>
          <cx:pt idx="257">6.8154755028628413</cx:pt>
          <cx:pt idx="258">5.0930751263695138</cx:pt>
          <cx:pt idx="259">4.8084375072975085</cx:pt>
          <cx:pt idx="260">7.4947805429810312</cx:pt>
          <cx:pt idx="261">6.3555172086355993</cx:pt>
          <cx:pt idx="262">4.7874084059762971</cx:pt>
          <cx:pt idx="263">7.6514054417151893</cx:pt>
          <cx:pt idx="264">7.690861986463867</cx:pt>
          <cx:pt idx="265">7.5960758300840041</cx:pt>
          <cx:pt idx="266">4.4819850854177128</cx:pt>
          <cx:pt idx="267">7.6994165921128435</cx:pt>
          <cx:pt idx="268">6.3694042841513943</cx:pt>
          <cx:pt idx="269">7.5428124354174102</cx:pt>
          <cx:pt idx="270">5.2852321269993814</cx:pt>
          <cx:pt idx="271">8.6140930161561968</cx:pt>
          <cx:pt idx="272">5.1321447114934529</cx:pt>
          <cx:pt idx="273">8.5712968330759143</cx:pt>
          <cx:pt idx="274">9.1560277872734286</cx:pt>
          <cx:pt idx="275">8.4522919378325394</cx:pt>
          <cx:pt idx="276">8.5784011724573528</cx:pt>
          <cx:pt idx="277">10.850381201568261</cx:pt>
          <cx:pt idx="278">8.5018460238021554</cx:pt>
          <cx:pt idx="279">3.6354786773868213</cx:pt>
          <cx:pt idx="280">4.5550341164942942</cx:pt>
          <cx:pt idx="281">7.7540955381584764</cx:pt>
          <cx:pt idx="282">5.8703697837299229</cx:pt>
          <cx:pt idx="283">6.2868357324190729</cx:pt>
          <cx:pt idx="284">5.4185418638544052</cx:pt>
          <cx:pt idx="285">7.828814622931394</cx:pt>
          <cx:pt idx="286">7.5656379104417715</cx:pt>
          <cx:pt idx="287">7.7912748545257475</cx:pt>
          <cx:pt idx="288">4.6388950553897121</cx:pt>
          <cx:pt idx="289">11.959929110820227</cx:pt>
          <cx:pt idx="290">10.513160728584335</cx:pt>
          <cx:pt idx="291">5.0946087278724344</cx:pt>
          <cx:pt idx="292">3.5613301331669613</cx:pt>
          <cx:pt idx="293">5.2182996585620058</cx:pt>
          <cx:pt idx="294">3.9958125311578292</cx:pt>
          <cx:pt idx="295">5.9703685838132472</cx:pt>
          <cx:pt idx="296">4.7794595710847814</cx:pt>
          <cx:pt idx="297">6.7950344089180179</cx:pt>
          <cx:pt idx="298">7.8497917272747078</cx:pt>
          <cx:pt idx="299">4.8066405616208066</cx:pt>
          <cx:pt idx="300">5.6830694330586597</cx:pt>
          <cx:pt idx="301">8.2613198154791085</cx:pt>
          <cx:pt idx="302">12.48786616443145</cx:pt>
          <cx:pt idx="303">11.673090025114263</cx:pt>
          <cx:pt idx="304">12.006517438790189</cx:pt>
          <cx:pt idx="305">3.3523572162426816</cx:pt>
          <cx:pt idx="306">4.6061696863211745</cx:pt>
          <cx:pt idx="307">4.9128754496453384</cx:pt>
          <cx:pt idx="308">5.6690875048593146</cx:pt>
          <cx:pt idx="309">7.134890851565884</cx:pt>
          <cx:pt idx="310">7.2776622916895874</cx:pt>
          <cx:pt idx="311">7.4265490723973047</cx:pt>
          <cx:pt idx="312">6.7691826291181973</cx:pt>
          <cx:pt idx="313">6.2488162697519289</cx:pt>
          <cx:pt idx="314">6.4723462945009009</cx:pt>
          <cx:pt idx="315">7.6551444023897597</cx:pt>
          <cx:pt idx="316">6.1101360768254809</cx:pt>
          <cx:pt idx="317">7.8035167196037998</cx:pt>
          <cx:pt idx="318">7.6348206777455427</cx:pt>
          <cx:pt idx="319">8.8194288448755298</cx:pt>
          <cx:pt idx="320">9.2056091976002818</cx:pt>
          <cx:pt idx="321">6.7945865808764987</cx:pt>
          <cx:pt idx="322">6.6778388433804983</cx:pt>
          <cx:pt idx="323">7.6923780238697459</cx:pt>
          <cx:pt idx="324">3.8396673432360058</cx:pt>
          <cx:pt idx="325">3.1759683238569241</cx:pt>
          <cx:pt idx="326">5.7844403776736559</cx:pt>
          <cx:pt idx="327">6.1679356902237608</cx:pt>
          <cx:pt idx="328">5.6204008657171496</cx:pt>
          <cx:pt idx="329">6.2225762680713688</cx:pt>
          <cx:pt idx="330">6.9603477291013078</cx:pt>
          <cx:pt idx="331">8.8526077260106817</cx:pt>
          <cx:pt idx="332">10.60038270068255</cx:pt>
          <cx:pt idx="333">9.6757208308196638</cx:pt>
          <cx:pt idx="334">7.5770195190787506</cx:pt>
          <cx:pt idx="335">6.670005575278565</cx:pt>
          <cx:pt idx="336">6.6184719251633819</cx:pt>
          <cx:pt idx="337">6.805944012835452</cx:pt>
          <cx:pt idx="338">12.489226229839794</cx:pt>
          <cx:pt idx="339">7.6912549155726335</cx:pt>
          <cx:pt idx="340">7.1356714233344833</cx:pt>
          <cx:pt idx="341">4.8561623401220402</cx:pt>
          <cx:pt idx="342">8.3180981428591672</cx:pt>
          <cx:pt idx="343">9.3367756466039342</cx:pt>
          <cx:pt idx="344">5.4080682305071557</cx:pt>
          <cx:pt idx="345">5.0204536030335944</cx:pt>
          <cx:pt idx="346">8.5382773501412981</cx:pt>
          <cx:pt idx="347">2.7067159780890733</cx:pt>
          <cx:pt idx="348">8.032827722907367</cx:pt>
          <cx:pt idx="349">3.2425923514855168</cx:pt>
          <cx:pt idx="350">2.7694588292308535</cx:pt>
          <cx:pt idx="351">3.8956903508072482</cx:pt>
          <cx:pt idx="352">5.0749237839786181</cx:pt>
          <cx:pt idx="353">10.823869902313536</cx:pt>
          <cx:pt idx="354">9.8769895612298999</cx:pt>
          <cx:pt idx="355">10.852400351227539</cx:pt>
          <cx:pt idx="356">8.0361852360594295</cx:pt>
          <cx:pt idx="357">6.7860395202980408</cx:pt>
          <cx:pt idx="358">6.4658336338633573</cx:pt>
          <cx:pt idx="359">8.9032715857242124</cx:pt>
          <cx:pt idx="360">6.7245533347608752</cx:pt>
          <cx:pt idx="361">4.5367842731216266</cx:pt>
          <cx:pt idx="362">6.8991180855864735</cx:pt>
          <cx:pt idx="363">7.4823441234179473</cx:pt>
          <cx:pt idx="364">9.8956065790852517</cx:pt>
          <cx:pt idx="365">8.0433421704416084</cx:pt>
          <cx:pt idx="366">6.1544333753861213</cx:pt>
          <cx:pt idx="367">8.0629369191381404</cx:pt>
          <cx:pt idx="368">7.4288084229035638</cx:pt>
          <cx:pt idx="369">7.7058929067330197</cx:pt>
          <cx:pt idx="370">10.498498062527567</cx:pt>
          <cx:pt idx="371">7.1429854914314941</cx:pt>
          <cx:pt idx="372">10.356186058125473</cx:pt>
          <cx:pt idx="373">6.7840044715459618</cx:pt>
          <cx:pt idx="374">7.2299836951865011</cx:pt>
          <cx:pt idx="375">7.8707769133438985</cx:pt>
          <cx:pt idx="376">7.5151266825206786</cx:pt>
          <cx:pt idx="377">8.2068564283996501</cx:pt>
          <cx:pt idx="378">7.8676417549739384</cx:pt>
          <cx:pt idx="379">6.8336780755858211</cx:pt>
          <cx:pt idx="380">6.9304947659516261</cx:pt>
          <cx:pt idx="381">5.9894625444373091</cx:pt>
          <cx:pt idx="382">6.3975960997593067</cx:pt>
          <cx:pt idx="383">6.6283058914568329</cx:pt>
          <cx:pt idx="384">4.0375978283362119</cx:pt>
          <cx:pt idx="385">4.6374437465383869</cx:pt>
          <cx:pt idx="386">5.1083667825895906</cx:pt>
          <cx:pt idx="387">6.6120410348330916</cx:pt>
          <cx:pt idx="388">7.9762519437456234</cx:pt>
          <cx:pt idx="389">7.7528507158141409</cx:pt>
          <cx:pt idx="390">4.5229835150001438</cx:pt>
          <cx:pt idx="391">3.9638561540681634</cx:pt>
          <cx:pt idx="392">9.5028756485579322</cx:pt>
          <cx:pt idx="393">4.2563216782988231</cx:pt>
          <cx:pt idx="394">5.1795338305580696</cx:pt>
          <cx:pt idx="395">7.7062754751217843</cx:pt>
          <cx:pt idx="396">8.9306793778268005</cx:pt>
          <cx:pt idx="397">4.5541926312232235</cx:pt>
          <cx:pt idx="398">5.089877681599023</cx:pt>
          <cx:pt idx="399">10.320657227502911</cx:pt>
        </cx:lvl>
      </cx:numDim>
    </cx:data>
    <cx:data id="1">
      <cx:numDim type="val">
        <cx:f>Sheet2!$J$2:$J$401</cx:f>
        <cx:lvl ptCount="400" formatCode="G/표준">
          <cx:pt idx="0">4.8917766802129394</cx:pt>
          <cx:pt idx="1">5.0078982183863694</cx:pt>
          <cx:pt idx="2">5.0369526024136295</cx:pt>
          <cx:pt idx="3">4.8528892698683421</cx:pt>
          <cx:pt idx="4">4.9292082954005263</cx:pt>
          <cx:pt idx="5">4.9754225383405108</cx:pt>
          <cx:pt idx="6">4.9126548857360524</cx:pt>
          <cx:pt idx="7">4.9218769374804889</cx:pt>
          <cx:pt idx="8">5.0786054205355233</cx:pt>
          <cx:pt idx="9">5.1608353232267739</cx:pt>
          <cx:pt idx="10">5.1900080630411853</cx:pt>
          <cx:pt idx="11">5.3302519850783829</cx:pt>
          <cx:pt idx="12">5.2350047603362704</cx:pt>
          <cx:pt idx="13">6.1794782064384535</cx:pt>
          <cx:pt idx="14">5.3068310223132418</cx:pt>
          <cx:pt idx="15">5.0696586345457169</cx:pt>
          <cx:pt idx="16">5.0118345746717381</cx:pt>
          <cx:pt idx="17">5.1562352346135807</cx:pt>
          <cx:pt idx="18">5.1594000673613678</cx:pt>
          <cx:pt idx="19">5.1730375501212791</cx:pt>
          <cx:pt idx="20">5.0928295317222423</cx:pt>
          <cx:pt idx="21">5.3159116749489881</cx:pt>
          <cx:pt idx="22">4.7118698046471472</cx:pt>
          <cx:pt idx="23">2.67000213346468</cx:pt>
          <cx:pt idx="24">0.16551443847757333</cx:pt>
          <cx:pt idx="25">3.2088254890146994</cx:pt>
          <cx:pt idx="26">2.8443278193947581</cx:pt>
          <cx:pt idx="27">3.9367156180185177</cx:pt>
          <cx:pt idx="28">1.9080599249242156</cx:pt>
          <cx:pt idx="29">2.6651427000909336</cx:pt>
          <cx:pt idx="30">3.1018924693823817</cx:pt>
          <cx:pt idx="31">3.0661907372025525</cx:pt>
          <cx:pt idx="32">4.5235261969475813</cx:pt>
          <cx:pt idx="33">1.8946168546677629</cx:pt>
          <cx:pt idx="34">2.3758355547336385</cx:pt>
          <cx:pt idx="35">2.9139797716817317</cx:pt>
          <cx:pt idx="36">3.0619880693310564</cx:pt>
          <cx:pt idx="37">2.0906287310704004</cx:pt>
          <cx:pt idx="38">2.2267833795777636</cx:pt>
          <cx:pt idx="39">2.1781550146158688</cx:pt>
          <cx:pt idx="40">2.2854389341590751</cx:pt>
          <cx:pt idx="41">3.5748705375020688</cx:pt>
          <cx:pt idx="42">3.8372994592322094</cx:pt>
          <cx:pt idx="43">3.8680711178989635</cx:pt>
          <cx:pt idx="44">3.6309854756950335</cx:pt>
          <cx:pt idx="45">4.1253586157512698</cx:pt>
          <cx:pt idx="46">3.8093256071898036</cx:pt>
          <cx:pt idx="47">4.3288895362607525</cx:pt>
          <cx:pt idx="48">4.0267792427263345</cx:pt>
          <cx:pt idx="49">4.4769958472645834</cx:pt>
          <cx:pt idx="50">4.2175941107156669</cx:pt>
          <cx:pt idx="51">4.342375829044089</cx:pt>
          <cx:pt idx="52">3.9497040723958348</cx:pt>
          <cx:pt idx="53">4.2787472852198798</cx:pt>
          <cx:pt idx="54">5.1258075171380746</cx:pt>
          <cx:pt idx="55">4.8090901423345418</cx:pt>
          <cx:pt idx="56">4.8485868421418568</cx:pt>
          <cx:pt idx="57">4.5391372153836533</cx:pt>
          <cx:pt idx="58">4.5232006231208404</cx:pt>
          <cx:pt idx="59">4.787325062224947</cx:pt>
          <cx:pt idx="60">4.7755878382792218</cx:pt>
          <cx:pt idx="61">4.7194805321655018</cx:pt>
          <cx:pt idx="62">4.9157383622265733</cx:pt>
          <cx:pt idx="63">5.0901855728542644</cx:pt>
          <cx:pt idx="64">4.9623549999210237</cx:pt>
          <cx:pt idx="65">5.1340910980231742</cx:pt>
          <cx:pt idx="66">2.0605135317943168</cx:pt>
          <cx:pt idx="67">1.9865035460205669</cx:pt>
          <cx:pt idx="68">3.48216274048526</cx:pt>
          <cx:pt idx="69">3.6908774567766094</cx:pt>
          <cx:pt idx="70">3.5201649007261984</cx:pt>
          <cx:pt idx="71">1.2499017362143359</cx:pt>
          <cx:pt idx="72">3.9819221328078132</cx:pt>
          <cx:pt idx="73">3.2876553402630266</cx:pt>
          <cx:pt idx="74">1.5769147207285403</cx:pt>
          <cx:pt idx="75">3.4946877247494941</cx:pt>
          <cx:pt idx="76">4.5695430083449402</cx:pt>
          <cx:pt idx="77">2.8213788864092133</cx:pt>
          <cx:pt idx="78">4.3610583282376849</cx:pt>
          <cx:pt idx="79">4.3013587316064266</cx:pt>
          <cx:pt idx="80">4.5829245770407718</cx:pt>
          <cx:pt idx="81">4.2008044733232275</cx:pt>
          <cx:pt idx="82">4.166510173022286</cx:pt>
          <cx:pt idx="83">4.5788262106484892</cx:pt>
          <cx:pt idx="84">4.3098590863718194</cx:pt>
          <cx:pt idx="85">4.5806725543876912</cx:pt>
          <cx:pt idx="86">5.3550284581320788</cx:pt>
          <cx:pt idx="87">5.4273260471115705</cx:pt>
          <cx:pt idx="88">2.982140320034524</cx:pt>
          <cx:pt idx="89">4.2456340097683265</cx:pt>
          <cx:pt idx="90">4.0005831824076266</cx:pt>
          <cx:pt idx="91">4.3412046401536264</cx:pt>
          <cx:pt idx="92">5.0997444691680318</cx:pt>
          <cx:pt idx="93">4.1469370123412714</cx:pt>
          <cx:pt idx="94">3.2503744919275719</cx:pt>
          <cx:pt idx="95">4.2236168979262398</cx:pt>
          <cx:pt idx="96">3.2726061472891685</cx:pt>
          <cx:pt idx="97">3.7607348912143643</cx:pt>
          <cx:pt idx="98">5.3917621712579002</cx:pt>
          <cx:pt idx="99">2.7479117345273405</cx:pt>
          <cx:pt idx="100">3.2519236789144013</cx:pt>
          <cx:pt idx="101">4.4143728107130933</cx:pt>
          <cx:pt idx="102">4.5446768055591287</cx:pt>
          <cx:pt idx="103">3.946231176757883</cx:pt>
          <cx:pt idx="104">5.0391579610294572</cx:pt>
          <cx:pt idx="105">2.4595888418037104</cx:pt>
          <cx:pt idx="106">3.1896529661912973</cx:pt>
          <cx:pt idx="107">4.0049667510708842</cx:pt>
          <cx:pt idx="108">3.916413353729439</cx:pt>
          <cx:pt idx="109">4.4172731148609508</cx:pt>
          <cx:pt idx="110">4.6644762918854985</cx:pt>
          <cx:pt idx="111">5.3997903354786709</cx:pt>
          <cx:pt idx="112">4.7067335013975322</cx:pt>
          <cx:pt idx="113">4.5092097948421799</cx:pt>
          <cx:pt idx="114">4.6956505391164658</cx:pt>
          <cx:pt idx="115">4.5784154486792721</cx:pt>
          <cx:pt idx="116">4.8931272206343035</cx:pt>
          <cx:pt idx="117">4.7785350847391541</cx:pt>
          <cx:pt idx="118">5.1653572392918061</cx:pt>
          <cx:pt idx="119">4.6094609674052478</cx:pt>
          <cx:pt idx="120">4.8529673247409573</cx:pt>
          <cx:pt idx="121">4.8396887953238066</cx:pt>
          <cx:pt idx="122">4.7815575032938549</cx:pt>
          <cx:pt idx="123">4.6491870714048655</cx:pt>
          <cx:pt idx="124">5.0022670444257393</cx:pt>
          <cx:pt idx="125">4.9783875465461351</cx:pt>
          <cx:pt idx="126">4.7651609222970324</cx:pt>
          <cx:pt idx="127">4.6381212861277774</cx:pt>
          <cx:pt idx="128">4.5933000134176041</cx:pt>
          <cx:pt idx="129">4.8440295937423041</cx:pt>
          <cx:pt idx="130">5.2397874243576332</cx:pt>
          <cx:pt idx="131">5.0261148649446419</cx:pt>
          <cx:pt idx="132">2.0241930674493576</cx:pt>
          <cx:pt idx="133">2.6195832197798796</cx:pt>
          <cx:pt idx="134">2.664446563620078</cx:pt>
          <cx:pt idx="135">3.2865344733420154</cx:pt>
          <cx:pt idx="136">3.5192766697277564</cx:pt>
          <cx:pt idx="137">-0.94160853985844495</cx:pt>
          <cx:pt idx="138">3.2204745462318978</cx:pt>
          <cx:pt idx="139">4.1585705345213722</cx:pt>
          <cx:pt idx="140">3.5325179989895132</cx:pt>
          <cx:pt idx="141">4.253624919869357</cx:pt>
          <cx:pt idx="142">3.7963876618292214</cx:pt>
          <cx:pt idx="143">1.4036429994545037</cx:pt>
          <cx:pt idx="144">3.4713451415642371</cx:pt>
          <cx:pt idx="145">3.3484995926617063</cx:pt>
          <cx:pt idx="146">3.4232849781261603</cx:pt>
          <cx:pt idx="147">2.4997952622817508</cx:pt>
          <cx:pt idx="148">3.6238074573702215</cx:pt>
          <cx:pt idx="149">3.2604015716966992</cx:pt>
          <cx:pt idx="150">3.721346644251438</cx:pt>
          <cx:pt idx="151">2.4940315575650009</cx:pt>
          <cx:pt idx="152">4.4473461007945243</cx:pt>
          <cx:pt idx="153">3.9041924263129575</cx:pt>
          <cx:pt idx="154">3.942358205224219</cx:pt>
          <cx:pt idx="155">3.259249719006474</cx:pt>
          <cx:pt idx="156">3.396184839838611</cx:pt>
          <cx:pt idx="157">2.5193080765053328</cx:pt>
          <cx:pt idx="158">3.503152104185149</cx:pt>
          <cx:pt idx="159">4.0434020834845263</cx:pt>
          <cx:pt idx="160">3.707701208354524</cx:pt>
          <cx:pt idx="161">3.8013148834437245</cx:pt>
          <cx:pt idx="162">4.2605649661366893</cx:pt>
          <cx:pt idx="163">2.7905514226139538</cx:pt>
          <cx:pt idx="164">4.1902606190519274</cx:pt>
          <cx:pt idx="165">3.5712214106457041</cx:pt>
          <cx:pt idx="166">4.2842759793301965</cx:pt>
          <cx:pt idx="167">2.252343876557299</cx:pt>
          <cx:pt idx="168">2.5989791060478482</cx:pt>
          <cx:pt idx="169">3.1389664416398988</cx:pt>
          <cx:pt idx="170">3.5112468868061133</cx:pt>
          <cx:pt idx="171">2.3608540011180215</cx:pt>
          <cx:pt idx="172">7.8725046915197083</cx:pt>
          <cx:pt idx="173">4.8291933503293087</cx:pt>
          <cx:pt idx="174">4.5134933974161875</cx:pt>
          <cx:pt idx="175">4.2794400458987809</cx:pt>
          <cx:pt idx="176">4.6082653908953937</cx:pt>
          <cx:pt idx="177">4.0678294565663453</cx:pt>
          <cx:pt idx="178">4.3351970473170836</cx:pt>
          <cx:pt idx="179">4.3158868321693369</cx:pt>
          <cx:pt idx="180">4.8738987705227848</cx:pt>
          <cx:pt idx="181">3.6581624814518756</cx:pt>
          <cx:pt idx="182">4.7208176095140537</cx:pt>
          <cx:pt idx="183">4.3315225025001141</cx:pt>
          <cx:pt idx="184">5.4053764388414445</cx:pt>
          <cx:pt idx="185">2.3905959703167592</cx:pt>
          <cx:pt idx="186">5.1815588059378408</cx:pt>
          <cx:pt idx="187">2.4865719291070616</cx:pt>
          <cx:pt idx="188">2.9816333491744893</cx:pt>
          <cx:pt idx="189">1.0543120297715298</cx:pt>
          <cx:pt idx="190">1.665818245870208</cx:pt>
          <cx:pt idx="191">2.3485140248824456</cx:pt>
          <cx:pt idx="192">2.5967461315435356</cx:pt>
          <cx:pt idx="193">3.0155349008501706</cx:pt>
          <cx:pt idx="194">4.5517694092609764</cx:pt>
          <cx:pt idx="195">2.3045830956567186</cx:pt>
          <cx:pt idx="196">3.3555024224000256</cx:pt>
          <cx:pt idx="197">3.8815637979434374</cx:pt>
          <cx:pt idx="198">4.7238417157055901</cx:pt>
          <cx:pt idx="199">3.8327633244425141</cx:pt>
          <cx:pt idx="200">3.9651845535423784</cx:pt>
          <cx:pt idx="201">3.6317798620733637</cx:pt>
          <cx:pt idx="202">4.8046765675361467</cx:pt>
          <cx:pt idx="203">4.7196589124727897</cx:pt>
          <cx:pt idx="204">2.7343675094195836</cx:pt>
          <cx:pt idx="205">4.0194414021954161</cx:pt>
          <cx:pt idx="206">5.2586925717647688</cx:pt>
          <cx:pt idx="207">4.3981460165537651</cx:pt>
          <cx:pt idx="208">5.0973632976060799</cx:pt>
          <cx:pt idx="209">4.5654933688351926</cx:pt>
          <cx:pt idx="210">5.1825136208043938</cx:pt>
          <cx:pt idx="211">4.41267707387264</cx:pt>
          <cx:pt idx="212">3.4216533902295376</cx:pt>
          <cx:pt idx="213">4.1717684591869046</cx:pt>
          <cx:pt idx="214">3.358289880650879</cx:pt>
          <cx:pt idx="215">3.4310797561440252</cx:pt>
          <cx:pt idx="216">3.6798387094617873</cx:pt>
          <cx:pt idx="217">3.6224725219163374</cx:pt>
          <cx:pt idx="218">3.8699502290062382</cx:pt>
          <cx:pt idx="219">4.2986450257348308</cx:pt>
          <cx:pt idx="220">4.8226175447574198</cx:pt>
          <cx:pt idx="221">4.6823163951647446</cx:pt>
          <cx:pt idx="222">3.8245024078986507</cx:pt>
          <cx:pt idx="223">3.9098205818729461</cx:pt>
          <cx:pt idx="224">3.8940626800511531</cx:pt>
          <cx:pt idx="225">4.3699540534396126</cx:pt>
          <cx:pt idx="226">4.4123133272787536</cx:pt>
          <cx:pt idx="227">3.7497393423706988</cx:pt>
          <cx:pt idx="228">4.6951936886356798</cx:pt>
          <cx:pt idx="229">3.9693480720474157</cx:pt>
          <cx:pt idx="230">3.8351419610921882</cx:pt>
          <cx:pt idx="231">4.5235261969475813</cx:pt>
          <cx:pt idx="232">4.4649881553882294</cx:pt>
          <cx:pt idx="233">4.7038383577847931</cx:pt>
          <cx:pt idx="234">4.6212403661655861</cx:pt>
          <cx:pt idx="235">4.6064693417197118</cx:pt>
          <cx:pt idx="236">4.4350933556105741</cx:pt>
          <cx:pt idx="237">4.2642279738954265</cx:pt>
          <cx:pt idx="238">5.1266389698525616</cx:pt>
          <cx:pt idx="239">4.5118480287567184</cx:pt>
          <cx:pt idx="240">4.8275134171315317</cx:pt>
          <cx:pt idx="241">4.9277608029280611</cx:pt>
          <cx:pt idx="242">4.7887409621824784</cx:pt>
          <cx:pt idx="243">1.2470322937863829</cx:pt>
          <cx:pt idx="244">3.3914836894745162</cx:pt>
          <cx:pt idx="245">3.3072529354856135</cx:pt>
          <cx:pt idx="246">4.1846422002028811</cx:pt>
          <cx:pt idx="247">3.0544727685765913</cx:pt>
          <cx:pt idx="248">0.9895411936137477</cx:pt>
          <cx:pt idx="249">2.3767644911682972</cx:pt>
          <cx:pt idx="250">2.5136560630739861</cx:pt>
          <cx:pt idx="251">1.9782390361706734</cx:pt>
          <cx:pt idx="252">3.9516282600205055</cx:pt>
          <cx:pt idx="253">3.7179527015996432</cx:pt>
          <cx:pt idx="254">3.6472759042588612</cx:pt>
          <cx:pt idx="255">4.3842741072143614</cx:pt>
          <cx:pt idx="256">4.9170569471366896</cx:pt>
          <cx:pt idx="257">3.6627921193506179</cx:pt>
          <cx:pt idx="258">4.1696066300558936</cx:pt>
          <cx:pt idx="259">4.7485776492828204</cx:pt>
          <cx:pt idx="260">4.816241156068032</cx:pt>
          <cx:pt idx="261">-0.31471074483970024</cx:pt>
          <cx:pt idx="262">4.2361334344934782</cx:pt>
          <cx:pt idx="263">-0.69314718055994529</cx:pt>
          <cx:pt idx="264">3.188416617383492</cx:pt>
          <cx:pt idx="265">1.8261608959453874</cx:pt>
          <cx:pt idx="266">2.3646204839134985</cx:pt>
          <cx:pt idx="267">2.8604851241459652</cx:pt>
          <cx:pt idx="268">-0.86750056770472306</cx:pt>
          <cx:pt idx="269">2.3437270363252209</cx:pt>
          <cx:pt idx="270">1.8825138324965192</cx:pt>
          <cx:pt idx="271">2.4638532405901681</cx:pt>
          <cx:pt idx="272">-0.82098055206983023</cx:pt>
          <cx:pt idx="273">2.3331142980288688</cx:pt>
          <cx:pt idx="274">-1.0216512475319814</cx:pt>
          <cx:pt idx="275">3.3537563070620187</cx:pt>
          <cx:pt idx="276">4.2452041179511451</cx:pt>
          <cx:pt idx="277">3.9678360702473587</cx:pt>
          <cx:pt idx="278">2.5336968139574321</cx:pt>
          <cx:pt idx="279">2.0281482472922852</cx:pt>
          <cx:pt idx="280">0.69813472207098426</cx:pt>
          <cx:pt idx="281">2.5771819258971713</cx:pt>
          <cx:pt idx="282">3.6846203971935529</cx:pt>
          <cx:pt idx="283">3.5424075502136789</cx:pt>
          <cx:pt idx="284">0.57661336430399379</cx:pt>
          <cx:pt idx="285">3.5386377907833935</cx:pt>
          <cx:pt idx="286">2.8518619031342891</cx:pt>
          <cx:pt idx="287">4.1133298621331811</cx:pt>
          <cx:pt idx="288">0.17395330712343798</cx:pt>
          <cx:pt idx="289">3.2835393381939229</cx:pt>
          <cx:pt idx="290">3.2962071678045244</cx:pt>
          <cx:pt idx="291">1.9183921201614209</cx:pt>
          <cx:pt idx="292">3.0773122605464138</cx:pt>
          <cx:pt idx="293">4.0129537240065867</cx:pt>
          <cx:pt idx="294">2.0241930674493576</cx:pt>
          <cx:pt idx="295">2.7555697170701863</cx:pt>
          <cx:pt idx="296">1.1724821372345651</cx:pt>
          <cx:pt idx="297">2.1004689088719113</cx:pt>
          <cx:pt idx="298">3.1616703510974213</cx:pt>
          <cx:pt idx="299">2.9019708937395166</cx:pt>
          <cx:pt idx="300">2.5201129055226197</cx:pt>
          <cx:pt idx="301">1.5518087995974639</cx:pt>
          <cx:pt idx="302">4.2266877492098134</cx:pt>
          <cx:pt idx="303">2.0438143640366846</cx:pt>
          <cx:pt idx="304">3.9286834463212532</cx:pt>
          <cx:pt idx="305">2.5136560630739861</cx:pt>
          <cx:pt idx="306">3.4787755163075302</cx:pt>
          <cx:pt idx="307">3.1830413718589847</cx:pt>
          <cx:pt idx="308">2.8853592160726205</cx:pt>
          <cx:pt idx="309">4.1343662365715863</cx:pt>
          <cx:pt idx="310">4.168988105217867</cx:pt>
          <cx:pt idx="311">4.0876555740713041</cx:pt>
          <cx:pt idx="312">4.5028051793100632</cx:pt>
          <cx:pt idx="313">4.0296282475024094</cx:pt>
          <cx:pt idx="314">3.7778056633083379</cx:pt>
          <cx:pt idx="315">3.5464514609816584</cx:pt>
          <cx:pt idx="316">3.3054204262683866</cx:pt>
          <cx:pt idx="317">4.6576677549458454</cx:pt>
          <cx:pt idx="318">3.7930142188459439</cx:pt>
          <cx:pt idx="319">2.7440606386252431</cx:pt>
          <cx:pt idx="320">4.7040195500302602</cx:pt>
          <cx:pt idx="321">3.9998507157936665</cx:pt>
          <cx:pt idx="322">3.7819143200811256</cx:pt>
          <cx:pt idx="323">3.3282682016393976</cx:pt>
          <cx:pt idx="324">3.436242723404956</cx:pt>
          <cx:pt idx="325">3.7328963395307104</cx:pt>
          <cx:pt idx="326">4.1840329084856309</cx:pt>
          <cx:pt idx="327">2.9128939952449864</cx:pt>
          <cx:pt idx="328">3.6584202466292277</cx:pt>
          <cx:pt idx="329">3.7950396499423267</cx:pt>
          <cx:pt idx="330">3.4713451415642371</cx:pt>
          <cx:pt idx="331">4.5445705638591614</cx:pt>
          <cx:pt idx="332">4.2156768473896253</cx:pt>
          <cx:pt idx="333">4.2657736778496318</cx:pt>
          <cx:pt idx="334">3.7884985191426486</cx:pt>
          <cx:pt idx="335">3.6320445173613978</cx:pt>
          <cx:pt idx="336">4.2356994381033033</cx:pt>
          <cx:pt idx="337">3.906004933102583</cx:pt>
          <cx:pt idx="338">4.0827779258506354</cx:pt>
          <cx:pt idx="339">-0.73396917508020043</cx:pt>
          <cx:pt idx="340">2.7186603802142257</cx:pt>
          <cx:pt idx="341">-1.2039728043259361</cx:pt>
          <cx:pt idx="342">-0.73396917508020043</cx:pt>
          <cx:pt idx="343">3.6843692986360503</cx:pt>
          <cx:pt idx="344">-1.0216512475319814</cx:pt>
          <cx:pt idx="345">-0.65392646740666394</cx:pt>
          <cx:pt idx="346">-0.96758402626170559</cx:pt>
          <cx:pt idx="347">3.7256934272366524</cx:pt>
          <cx:pt idx="348">3.4499875458315872</cx:pt>
          <cx:pt idx="349">0.18232155679395459</cx:pt>
          <cx:pt idx="350">-0.52763274208237199</cx:pt>
          <cx:pt idx="351">3.2604015716966992</cx:pt>
          <cx:pt idx="352">1.8687205103641833</cx:pt>
          <cx:pt idx="353">3.3509561652254085</cx:pt>
          <cx:pt idx="354">3.677565694213663</cx:pt>
          <cx:pt idx="355">4.091674333666222</cx:pt>
          <cx:pt idx="356">4.1356464415792065</cx:pt>
          <cx:pt idx="357">4.0095126267054031</cx:pt>
          <cx:pt idx="358">3.7106409458954492</cx:pt>
          <cx:pt idx="359">3.9943400479173596</cx:pt>
          <cx:pt idx="360">3.6130777406976544</cx:pt>
          <cx:pt idx="361">4.1100538559272808</cx:pt>
          <cx:pt idx="362">3.962906215742716</cx:pt>
          <cx:pt idx="363">4.1852511209097765</cx:pt>
          <cx:pt idx="364">4.4183585639212719</cx:pt>
          <cx:pt idx="365">4.2590111837773348</cx:pt>
          <cx:pt idx="366">3.8484440237852748</cx:pt>
          <cx:pt idx="367">3.7527927798575891</cx:pt>
          <cx:pt idx="368">3.7424202210419661</cx:pt>
          <cx:pt idx="369">3.980989209892869</cx:pt>
          <cx:pt idx="370">4.3480819786209439</cx:pt>
          <cx:pt idx="371">4.2137559011025862</cx:pt>
          <cx:pt idx="372">4.2069289229692464</cx:pt>
          <cx:pt idx="373">4.8172932340188357</cx:pt>
          <cx:pt idx="374">3.3751955791231545</cx:pt>
          <cx:pt idx="375">3.541828511401901</cx:pt>
          <cx:pt idx="376">4.0766896269833799</cx:pt>
          <cx:pt idx="377">4.5597543224576089</cx:pt>
          <cx:pt idx="378">3.8640924716705958</cx:pt>
          <cx:pt idx="379">4.1746949148757588</cx:pt>
          <cx:pt idx="380">3.8854736701946093</cx:pt>
          <cx:pt idx="381">3.933980172780188</cx:pt>
          <cx:pt idx="382">4.7027505143269552</cx:pt>
          <cx:pt idx="383">6.9713402206072477</cx:pt>
          <cx:pt idx="384">3.7367167835280966</cx:pt>
          <cx:pt idx="385">3.1650530181706942</cx:pt>
          <cx:pt idx="386">5.0678974062630511</cx:pt>
          <cx:pt idx="387">4.7824792009585018</cx:pt>
          <cx:pt idx="388">3.3293432778941718</cx:pt>
          <cx:pt idx="389">4.5592309540466465</cx:pt>
          <cx:pt idx="390">2.8892600290434745</cx:pt>
          <cx:pt idx="391">2.8981194446869907</cx:pt>
          <cx:pt idx="392">3.3941727667251911</cx:pt>
          <cx:pt idx="393">2.6658383522929006</cx:pt>
          <cx:pt idx="394">4.0481260884204868</cx:pt>
          <cx:pt idx="395">4.3382053551250319</cx:pt>
          <cx:pt idx="396">3.2128577525426376</cx:pt>
          <cx:pt idx="397">1.2612978709452054</cx:pt>
          <cx:pt idx="398">3.1888289035159043</cx:pt>
          <cx:pt idx="399">4.3672936350718166</cx:pt>
        </cx:lvl>
      </cx:numDim>
    </cx:data>
  </cx:chartData>
  <cx:chart>
    <cx:plotArea>
      <cx:plotAreaRegion>
        <cx:series layoutId="boxWhisker" uniqueId="{0F3CC426-6EB3-4112-9E6E-4386DFEC6EDA}">
          <cx:tx>
            <cx:txData>
              <cx:f>Sheet2!$I$1</cx:f>
              <cx:v>baseline </cx:v>
            </cx:txData>
          </cx:tx>
          <cx:spPr>
            <a:solidFill>
              <a:schemeClr val="bg2">
                <a:lumMod val="90000"/>
              </a:schemeClr>
            </a:solidFill>
            <a:ln w="15875">
              <a:solidFill>
                <a:schemeClr val="bg2">
                  <a:lumMod val="25000"/>
                </a:schemeClr>
              </a:solidFill>
            </a:ln>
          </cx:spPr>
          <cx:dataId val="0"/>
          <cx:layoutPr>
            <cx:visibility meanLine="0" meanMarker="0" nonoutliers="0" outliers="0"/>
            <cx:statistics quartileMethod="inclusive"/>
          </cx:layoutPr>
        </cx:series>
        <cx:series layoutId="boxWhisker" uniqueId="{4D1369D6-94DF-4CA8-9074-205DD08D2056}">
          <cx:tx>
            <cx:txData>
              <cx:f>Sheet2!$J$1</cx:f>
              <cx:v>3Y</cx:v>
            </cx:txData>
          </cx:tx>
          <cx:spPr>
            <a:solidFill>
              <a:schemeClr val="accent5">
                <a:lumMod val="50000"/>
              </a:schemeClr>
            </a:solidFill>
            <a:ln w="12700">
              <a:solidFill>
                <a:schemeClr val="tx1"/>
              </a:solidFill>
            </a:ln>
          </cx:spPr>
          <cx:dataId val="1"/>
          <cx:layoutPr>
            <cx:visibility meanLine="1" meanMarker="0" nonoutliers="0" outliers="0"/>
            <cx:statistics quartileMethod="exclusive"/>
          </cx:layoutPr>
        </cx:series>
      </cx:plotAreaRegion>
      <cx:axis id="0">
        <cx:catScaling gapWidth="0.730000019"/>
        <cx:tickLabels/>
        <cx:spPr>
          <a:ln w="15875">
            <a:solidFill>
              <a:schemeClr val="tx1"/>
            </a:solidFill>
          </a:ln>
        </cx:spPr>
      </cx:axis>
      <cx:axis id="1">
        <cx:valScaling min="0"/>
        <cx:title>
          <cx:tx>
            <cx:rich>
              <a:bodyPr spcFirstLastPara="1" vertOverflow="ellipsis" horzOverflow="overflow" wrap="square" lIns="0" tIns="0" rIns="0" bIns="0" anchor="ctr" anchorCtr="1"/>
              <a:lstStyle/>
              <a:p>
                <a:pPr algn="ctr" rtl="0">
                  <a:defRPr sz="1100" b="1">
                    <a:solidFill>
                      <a:schemeClr val="tx1"/>
                    </a:solidFill>
                    <a:latin typeface="Arial" panose="020B0604020202020204" pitchFamily="34" charset="0"/>
                    <a:ea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altLang="ko-KR" sz="1100" b="1" i="0" u="none" strike="noStrike" baseline="0" dirty="0">
                    <a:solidFill>
                      <a:schemeClr val="tx1"/>
                    </a:solidFill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rPr>
                  <a:t>Log FGF23 (</a:t>
                </a:r>
                <a:r>
                  <a:rPr lang="en-US" altLang="ko-KR" sz="1100" b="1" i="0" u="none" strike="noStrike" baseline="0" dirty="0" err="1">
                    <a:solidFill>
                      <a:schemeClr val="tx1"/>
                    </a:solidFill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rPr>
                  <a:t>pg</a:t>
                </a:r>
                <a:r>
                  <a:rPr lang="en-US" altLang="ko-KR" sz="1100" b="1" i="0" u="none" strike="noStrike" baseline="0" dirty="0">
                    <a:solidFill>
                      <a:schemeClr val="tx1"/>
                    </a:solidFill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rPr>
                  <a:t>/mL)</a:t>
                </a:r>
                <a:endParaRPr lang="ko-KR" altLang="en-US" sz="1100" b="1" i="0" u="none" strike="noStrike" baseline="0" dirty="0">
                  <a:solidFill>
                    <a:schemeClr val="tx1"/>
                  </a:solidFill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endParaRPr>
              </a:p>
            </cx:rich>
          </cx:tx>
        </cx:title>
        <cx:tickLabels/>
        <cx:spPr>
          <a:ln w="15875">
            <a:solidFill>
              <a:schemeClr val="tx1"/>
            </a:solidFill>
          </a:ln>
        </cx:spPr>
        <cx:txPr>
          <a:bodyPr spcFirstLastPara="1" vertOverflow="ellipsis" horzOverflow="overflow" wrap="square" lIns="0" tIns="0" rIns="0" bIns="0" anchor="ctr" anchorCtr="1"/>
          <a:lstStyle/>
          <a:p>
            <a:pPr algn="ctr" rtl="0">
              <a:defRPr sz="1100" b="1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pPr>
            <a:endParaRPr lang="ko-KR" altLang="en-US" sz="1100" b="1" i="0" u="none" strike="noStrike" baseline="0">
              <a:solidFill>
                <a:sysClr val="windowText" lastClr="000000"/>
              </a:solidFill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cx:txPr>
      </cx:axis>
    </cx:plotArea>
  </cx:chart>
  <cx:spPr>
    <a:ln>
      <a:noFill/>
    </a:ln>
  </cx:spPr>
</cx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418A73C-DF7C-4F6B-8679-A4F748C3F421}" type="datetimeFigureOut">
              <a:rPr lang="ko-KR" altLang="en-US" smtClean="0"/>
              <a:t>2023-10-10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603DE19-65E6-48F6-85A0-99C8D94A7E8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3297388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603DE19-65E6-48F6-85A0-99C8D94A7E86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547673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0B9DAE-0D36-4AEC-83A1-7CD275415063}" type="datetimeFigureOut">
              <a:rPr lang="ko-KR" altLang="en-US" smtClean="0"/>
              <a:t>2023-10-1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F43196-92AC-4D32-AA66-C575C2EF210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190720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0B9DAE-0D36-4AEC-83A1-7CD275415063}" type="datetimeFigureOut">
              <a:rPr lang="ko-KR" altLang="en-US" smtClean="0"/>
              <a:t>2023-10-1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F43196-92AC-4D32-AA66-C575C2EF210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984584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0B9DAE-0D36-4AEC-83A1-7CD275415063}" type="datetimeFigureOut">
              <a:rPr lang="ko-KR" altLang="en-US" smtClean="0"/>
              <a:t>2023-10-1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F43196-92AC-4D32-AA66-C575C2EF210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056834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0B9DAE-0D36-4AEC-83A1-7CD275415063}" type="datetimeFigureOut">
              <a:rPr lang="ko-KR" altLang="en-US" smtClean="0"/>
              <a:t>2023-10-1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F43196-92AC-4D32-AA66-C575C2EF210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580507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0B9DAE-0D36-4AEC-83A1-7CD275415063}" type="datetimeFigureOut">
              <a:rPr lang="ko-KR" altLang="en-US" smtClean="0"/>
              <a:t>2023-10-1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F43196-92AC-4D32-AA66-C575C2EF210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18355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0B9DAE-0D36-4AEC-83A1-7CD275415063}" type="datetimeFigureOut">
              <a:rPr lang="ko-KR" altLang="en-US" smtClean="0"/>
              <a:t>2023-10-1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F43196-92AC-4D32-AA66-C575C2EF210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906471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0B9DAE-0D36-4AEC-83A1-7CD275415063}" type="datetimeFigureOut">
              <a:rPr lang="ko-KR" altLang="en-US" smtClean="0"/>
              <a:t>2023-10-10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F43196-92AC-4D32-AA66-C575C2EF210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267541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0B9DAE-0D36-4AEC-83A1-7CD275415063}" type="datetimeFigureOut">
              <a:rPr lang="ko-KR" altLang="en-US" smtClean="0"/>
              <a:t>2023-10-10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F43196-92AC-4D32-AA66-C575C2EF210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526610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0B9DAE-0D36-4AEC-83A1-7CD275415063}" type="datetimeFigureOut">
              <a:rPr lang="ko-KR" altLang="en-US" smtClean="0"/>
              <a:t>2023-10-10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F43196-92AC-4D32-AA66-C575C2EF210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009976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0B9DAE-0D36-4AEC-83A1-7CD275415063}" type="datetimeFigureOut">
              <a:rPr lang="ko-KR" altLang="en-US" smtClean="0"/>
              <a:t>2023-10-1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F43196-92AC-4D32-AA66-C575C2EF210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108477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0B9DAE-0D36-4AEC-83A1-7CD275415063}" type="datetimeFigureOut">
              <a:rPr lang="ko-KR" altLang="en-US" smtClean="0"/>
              <a:t>2023-10-1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F43196-92AC-4D32-AA66-C575C2EF210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376020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0B9DAE-0D36-4AEC-83A1-7CD275415063}" type="datetimeFigureOut">
              <a:rPr lang="ko-KR" altLang="en-US" smtClean="0"/>
              <a:t>2023-10-1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F43196-92AC-4D32-AA66-C575C2EF210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844029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35" r:id="rId1"/>
    <p:sldLayoutId id="2147483736" r:id="rId2"/>
    <p:sldLayoutId id="2147483737" r:id="rId3"/>
    <p:sldLayoutId id="2147483738" r:id="rId4"/>
    <p:sldLayoutId id="2147483739" r:id="rId5"/>
    <p:sldLayoutId id="2147483740" r:id="rId6"/>
    <p:sldLayoutId id="2147483741" r:id="rId7"/>
    <p:sldLayoutId id="2147483742" r:id="rId8"/>
    <p:sldLayoutId id="2147483743" r:id="rId9"/>
    <p:sldLayoutId id="2147483744" r:id="rId10"/>
    <p:sldLayoutId id="2147483745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14/relationships/chartEx" Target="../charts/chartEx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.png"/><Relationship Id="rId4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DE1966C3-FF87-4516-BF06-A6483BB535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40749" y="8910621"/>
            <a:ext cx="6532584" cy="675815"/>
          </a:xfrm>
        </p:spPr>
        <p:txBody>
          <a:bodyPr>
            <a:noAutofit/>
          </a:bodyPr>
          <a:lstStyle/>
          <a:p>
            <a:pPr>
              <a:lnSpc>
                <a:spcPct val="100000"/>
              </a:lnSpc>
            </a:pP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S1. Post-transplant changes in FGF-23 levels.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(a) FGF23 level in 3 years was decreased after kidney transplantation compared to FGF23 at baseline (*P=0.001). (b) Positive correlation in FGF23 levels between  baseline and 3 years after transplantation was observed (</a:t>
            </a:r>
            <a:r>
              <a:rPr lang="el-GR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lang="en-US" altLang="ko-KR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=0.095, P=0.001).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8" name="그룹 27">
            <a:extLst>
              <a:ext uri="{FF2B5EF4-FFF2-40B4-BE49-F238E27FC236}">
                <a16:creationId xmlns:a16="http://schemas.microsoft.com/office/drawing/2014/main" id="{514F17F7-3BD7-E14D-99C3-6C5C28461DCC}"/>
              </a:ext>
            </a:extLst>
          </p:cNvPr>
          <p:cNvGrpSpPr/>
          <p:nvPr/>
        </p:nvGrpSpPr>
        <p:grpSpPr>
          <a:xfrm>
            <a:off x="718127" y="794327"/>
            <a:ext cx="4768273" cy="3768572"/>
            <a:chOff x="718127" y="794327"/>
            <a:chExt cx="4768273" cy="3768572"/>
          </a:xfrm>
        </p:grpSpPr>
        <mc:AlternateContent xmlns:mc="http://schemas.openxmlformats.org/markup-compatibility/2006">
          <mc:Choice xmlns:cx1="http://schemas.microsoft.com/office/drawing/2015/9/8/chartex" Requires="cx1">
            <p:graphicFrame>
              <p:nvGraphicFramePr>
                <p:cNvPr id="6" name="차트 5">
                  <a:extLst>
                    <a:ext uri="{FF2B5EF4-FFF2-40B4-BE49-F238E27FC236}">
                      <a16:creationId xmlns:a16="http://schemas.microsoft.com/office/drawing/2014/main" id="{9A62C3C1-FCE6-22A0-61B0-7EDDD82E3255}"/>
                    </a:ext>
                  </a:extLst>
                </p:cNvPr>
                <p:cNvGraphicFramePr/>
                <p:nvPr>
                  <p:extLst>
                    <p:ext uri="{D42A27DB-BD31-4B8C-83A1-F6EECF244321}">
                      <p14:modId xmlns:p14="http://schemas.microsoft.com/office/powerpoint/2010/main" val="3091319908"/>
                    </p:ext>
                  </p:extLst>
                </p:nvPr>
              </p:nvGraphicFramePr>
              <p:xfrm>
                <a:off x="718127" y="794327"/>
                <a:ext cx="4768273" cy="3768572"/>
              </p:xfrm>
              <a:graphic>
                <a:graphicData uri="http://schemas.microsoft.com/office/drawing/2014/chartex">
                  <cx:chart xmlns:cx="http://schemas.microsoft.com/office/drawing/2014/chartex" xmlns:r="http://schemas.openxmlformats.org/officeDocument/2006/relationships" r:id="rId3"/>
                </a:graphicData>
              </a:graphic>
            </p:graphicFrame>
          </mc:Choice>
          <mc:Fallback>
            <p:pic>
              <p:nvPicPr>
                <p:cNvPr id="6" name="차트 5">
                  <a:extLst>
                    <a:ext uri="{FF2B5EF4-FFF2-40B4-BE49-F238E27FC236}">
                      <a16:creationId xmlns:a16="http://schemas.microsoft.com/office/drawing/2014/main" id="{9A62C3C1-FCE6-22A0-61B0-7EDDD82E3255}"/>
                    </a:ext>
                  </a:extLst>
                </p:cNvPr>
                <p:cNvPicPr>
                  <a:picLocks noGrp="1" noRot="1" noChangeAspect="1" noMove="1" noResize="1" noEditPoints="1" noAdjustHandles="1" noChangeArrowheads="1" noChangeShapeType="1"/>
                </p:cNvPicPr>
                <p:nvPr/>
              </p:nvPicPr>
              <p:blipFill>
                <a:blip r:embed="rId4"/>
                <a:stretch>
                  <a:fillRect/>
                </a:stretch>
              </p:blipFill>
              <p:spPr>
                <a:xfrm>
                  <a:off x="718127" y="794327"/>
                  <a:ext cx="4768273" cy="3768572"/>
                </a:xfrm>
                <a:prstGeom prst="rect">
                  <a:avLst/>
                </a:prstGeom>
              </p:spPr>
            </p:pic>
          </mc:Fallback>
        </mc:AlternateContent>
        <p:sp>
          <p:nvSpPr>
            <p:cNvPr id="8" name="직사각형 7">
              <a:extLst>
                <a:ext uri="{FF2B5EF4-FFF2-40B4-BE49-F238E27FC236}">
                  <a16:creationId xmlns:a16="http://schemas.microsoft.com/office/drawing/2014/main" id="{CFFF86EB-4176-9494-C155-78D6EED8E4BE}"/>
                </a:ext>
              </a:extLst>
            </p:cNvPr>
            <p:cNvSpPr/>
            <p:nvPr/>
          </p:nvSpPr>
          <p:spPr>
            <a:xfrm>
              <a:off x="2175559" y="4317868"/>
              <a:ext cx="1080654" cy="21732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sz="11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aseline</a:t>
              </a:r>
              <a:r>
                <a:rPr lang="ko-KR" altLang="en-US" sz="11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9" name="직사각형 8">
              <a:extLst>
                <a:ext uri="{FF2B5EF4-FFF2-40B4-BE49-F238E27FC236}">
                  <a16:creationId xmlns:a16="http://schemas.microsoft.com/office/drawing/2014/main" id="{6D4F7511-FB1B-B3CA-43D8-D805E6BB2395}"/>
                </a:ext>
              </a:extLst>
            </p:cNvPr>
            <p:cNvSpPr/>
            <p:nvPr/>
          </p:nvSpPr>
          <p:spPr>
            <a:xfrm>
              <a:off x="3290652" y="4317867"/>
              <a:ext cx="1080654" cy="21732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sz="11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 years</a:t>
              </a:r>
              <a:endParaRPr lang="ko-KR" altLang="en-US" sz="11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7" name="그룹 26">
            <a:extLst>
              <a:ext uri="{FF2B5EF4-FFF2-40B4-BE49-F238E27FC236}">
                <a16:creationId xmlns:a16="http://schemas.microsoft.com/office/drawing/2014/main" id="{B85E69D4-BFA5-13B8-4D2D-2EB9F2A123AF}"/>
              </a:ext>
            </a:extLst>
          </p:cNvPr>
          <p:cNvGrpSpPr/>
          <p:nvPr/>
        </p:nvGrpSpPr>
        <p:grpSpPr>
          <a:xfrm>
            <a:off x="810491" y="5243676"/>
            <a:ext cx="4946867" cy="3590881"/>
            <a:chOff x="810491" y="5243676"/>
            <a:chExt cx="4946867" cy="3590881"/>
          </a:xfrm>
        </p:grpSpPr>
        <p:pic>
          <p:nvPicPr>
            <p:cNvPr id="3" name="그림 2">
              <a:extLst>
                <a:ext uri="{FF2B5EF4-FFF2-40B4-BE49-F238E27FC236}">
                  <a16:creationId xmlns:a16="http://schemas.microsoft.com/office/drawing/2014/main" id="{4A1F3D37-6F31-4666-EF94-A89FABE7B42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r="17720"/>
            <a:stretch/>
          </p:blipFill>
          <p:spPr>
            <a:xfrm>
              <a:off x="810491" y="5292168"/>
              <a:ext cx="4946867" cy="3542389"/>
            </a:xfrm>
            <a:prstGeom prst="rect">
              <a:avLst/>
            </a:prstGeom>
          </p:spPr>
        </p:pic>
        <p:sp>
          <p:nvSpPr>
            <p:cNvPr id="10" name="직사각형 9">
              <a:extLst>
                <a:ext uri="{FF2B5EF4-FFF2-40B4-BE49-F238E27FC236}">
                  <a16:creationId xmlns:a16="http://schemas.microsoft.com/office/drawing/2014/main" id="{B9C835C6-70DF-920B-0185-A2E1B66EEA3A}"/>
                </a:ext>
              </a:extLst>
            </p:cNvPr>
            <p:cNvSpPr/>
            <p:nvPr/>
          </p:nvSpPr>
          <p:spPr>
            <a:xfrm>
              <a:off x="872040" y="5243676"/>
              <a:ext cx="360000" cy="21732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r>
                <a:rPr lang="en-US" altLang="ko-KR" sz="11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endParaRPr lang="ko-KR" altLang="en-US" sz="11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직사각형 10">
              <a:extLst>
                <a:ext uri="{FF2B5EF4-FFF2-40B4-BE49-F238E27FC236}">
                  <a16:creationId xmlns:a16="http://schemas.microsoft.com/office/drawing/2014/main" id="{0F76250F-3063-7B2C-907C-42FDAF921F36}"/>
                </a:ext>
              </a:extLst>
            </p:cNvPr>
            <p:cNvSpPr/>
            <p:nvPr/>
          </p:nvSpPr>
          <p:spPr>
            <a:xfrm>
              <a:off x="872040" y="5977968"/>
              <a:ext cx="360000" cy="21732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r>
                <a:rPr lang="en-US" altLang="ko-KR" sz="11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ko-KR" altLang="en-US" sz="11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직사각형 13">
              <a:extLst>
                <a:ext uri="{FF2B5EF4-FFF2-40B4-BE49-F238E27FC236}">
                  <a16:creationId xmlns:a16="http://schemas.microsoft.com/office/drawing/2014/main" id="{69E312DA-B7B6-77D7-3247-DAA3C7D3FB64}"/>
                </a:ext>
              </a:extLst>
            </p:cNvPr>
            <p:cNvSpPr/>
            <p:nvPr/>
          </p:nvSpPr>
          <p:spPr>
            <a:xfrm>
              <a:off x="872040" y="6739968"/>
              <a:ext cx="360000" cy="21732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r>
                <a:rPr lang="en-US" altLang="ko-KR" sz="11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ko-KR" altLang="en-US" sz="11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직사각형 14">
              <a:extLst>
                <a:ext uri="{FF2B5EF4-FFF2-40B4-BE49-F238E27FC236}">
                  <a16:creationId xmlns:a16="http://schemas.microsoft.com/office/drawing/2014/main" id="{049CBD61-CA2F-B39B-D264-FCA844EE76E9}"/>
                </a:ext>
              </a:extLst>
            </p:cNvPr>
            <p:cNvSpPr/>
            <p:nvPr/>
          </p:nvSpPr>
          <p:spPr>
            <a:xfrm>
              <a:off x="872040" y="7465021"/>
              <a:ext cx="360000" cy="21732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r>
                <a:rPr lang="en-US" altLang="ko-KR" sz="11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ko-KR" altLang="en-US" sz="11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직사각형 15">
              <a:extLst>
                <a:ext uri="{FF2B5EF4-FFF2-40B4-BE49-F238E27FC236}">
                  <a16:creationId xmlns:a16="http://schemas.microsoft.com/office/drawing/2014/main" id="{21A367BC-3E2C-4481-B950-818E07BCE8A7}"/>
                </a:ext>
              </a:extLst>
            </p:cNvPr>
            <p:cNvSpPr/>
            <p:nvPr/>
          </p:nvSpPr>
          <p:spPr>
            <a:xfrm>
              <a:off x="872040" y="8208547"/>
              <a:ext cx="360000" cy="21732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r>
                <a:rPr lang="en-US" altLang="ko-KR" sz="11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ko-KR" altLang="en-US" sz="11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직사각형 16">
              <a:extLst>
                <a:ext uri="{FF2B5EF4-FFF2-40B4-BE49-F238E27FC236}">
                  <a16:creationId xmlns:a16="http://schemas.microsoft.com/office/drawing/2014/main" id="{4CCA906C-062D-29A4-5CA6-227722AFF880}"/>
                </a:ext>
              </a:extLst>
            </p:cNvPr>
            <p:cNvSpPr/>
            <p:nvPr/>
          </p:nvSpPr>
          <p:spPr>
            <a:xfrm>
              <a:off x="1082851" y="8385087"/>
              <a:ext cx="360000" cy="21732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sz="11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ko-KR" altLang="en-US" sz="11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직사각형 17">
              <a:extLst>
                <a:ext uri="{FF2B5EF4-FFF2-40B4-BE49-F238E27FC236}">
                  <a16:creationId xmlns:a16="http://schemas.microsoft.com/office/drawing/2014/main" id="{EE9E0064-A428-7760-9770-7D0D498A8F04}"/>
                </a:ext>
              </a:extLst>
            </p:cNvPr>
            <p:cNvSpPr/>
            <p:nvPr/>
          </p:nvSpPr>
          <p:spPr>
            <a:xfrm>
              <a:off x="1674002" y="8385087"/>
              <a:ext cx="360000" cy="21732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sz="11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ko-KR" altLang="en-US" sz="11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직사각형 18">
              <a:extLst>
                <a:ext uri="{FF2B5EF4-FFF2-40B4-BE49-F238E27FC236}">
                  <a16:creationId xmlns:a16="http://schemas.microsoft.com/office/drawing/2014/main" id="{E42AB39D-4030-4BA4-DEEF-4590C23C8ECB}"/>
                </a:ext>
              </a:extLst>
            </p:cNvPr>
            <p:cNvSpPr/>
            <p:nvPr/>
          </p:nvSpPr>
          <p:spPr>
            <a:xfrm rot="16200000">
              <a:off x="61198" y="6619195"/>
              <a:ext cx="1740131" cy="24154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sz="11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og FGF23-3Y (</a:t>
              </a:r>
              <a:r>
                <a:rPr lang="en-US" altLang="ko-KR" sz="1100" b="1" dirty="0" err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g</a:t>
              </a:r>
              <a:r>
                <a:rPr lang="en-US" altLang="ko-KR" sz="11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/mL)</a:t>
              </a:r>
              <a:r>
                <a:rPr lang="ko-KR" altLang="en-US" sz="11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20" name="직사각형 19">
              <a:extLst>
                <a:ext uri="{FF2B5EF4-FFF2-40B4-BE49-F238E27FC236}">
                  <a16:creationId xmlns:a16="http://schemas.microsoft.com/office/drawing/2014/main" id="{83B867A4-B49F-6D06-A16A-1F48696910D4}"/>
                </a:ext>
              </a:extLst>
            </p:cNvPr>
            <p:cNvSpPr/>
            <p:nvPr/>
          </p:nvSpPr>
          <p:spPr>
            <a:xfrm>
              <a:off x="2379682" y="8537899"/>
              <a:ext cx="1885278" cy="28114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sz="11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og FGF23_B0 (</a:t>
              </a:r>
              <a:r>
                <a:rPr lang="en-US" altLang="ko-KR" sz="1100" b="1" dirty="0" err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g</a:t>
              </a:r>
              <a:r>
                <a:rPr lang="en-US" altLang="ko-KR" sz="11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/mL)</a:t>
              </a:r>
              <a:r>
                <a:rPr lang="ko-KR" altLang="en-US" sz="11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21" name="직사각형 20">
              <a:extLst>
                <a:ext uri="{FF2B5EF4-FFF2-40B4-BE49-F238E27FC236}">
                  <a16:creationId xmlns:a16="http://schemas.microsoft.com/office/drawing/2014/main" id="{D101AC3E-0B8D-B029-C3ED-364359256507}"/>
                </a:ext>
              </a:extLst>
            </p:cNvPr>
            <p:cNvSpPr/>
            <p:nvPr/>
          </p:nvSpPr>
          <p:spPr>
            <a:xfrm>
              <a:off x="2306362" y="8385087"/>
              <a:ext cx="360000" cy="21732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sz="11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ko-KR" altLang="en-US" sz="11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직사각형 21">
              <a:extLst>
                <a:ext uri="{FF2B5EF4-FFF2-40B4-BE49-F238E27FC236}">
                  <a16:creationId xmlns:a16="http://schemas.microsoft.com/office/drawing/2014/main" id="{E15F7865-7C36-3A18-E677-C503FA550654}"/>
                </a:ext>
              </a:extLst>
            </p:cNvPr>
            <p:cNvSpPr/>
            <p:nvPr/>
          </p:nvSpPr>
          <p:spPr>
            <a:xfrm>
              <a:off x="2904877" y="8385087"/>
              <a:ext cx="360000" cy="21732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sz="11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ko-KR" altLang="en-US" sz="11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직사각형 22">
              <a:extLst>
                <a:ext uri="{FF2B5EF4-FFF2-40B4-BE49-F238E27FC236}">
                  <a16:creationId xmlns:a16="http://schemas.microsoft.com/office/drawing/2014/main" id="{1980CFC2-91DF-FE3F-B85B-BE81B176F51F}"/>
                </a:ext>
              </a:extLst>
            </p:cNvPr>
            <p:cNvSpPr/>
            <p:nvPr/>
          </p:nvSpPr>
          <p:spPr>
            <a:xfrm>
              <a:off x="3535680" y="8385087"/>
              <a:ext cx="360000" cy="21732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sz="11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endParaRPr lang="ko-KR" altLang="en-US" sz="11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직사각형 23">
              <a:extLst>
                <a:ext uri="{FF2B5EF4-FFF2-40B4-BE49-F238E27FC236}">
                  <a16:creationId xmlns:a16="http://schemas.microsoft.com/office/drawing/2014/main" id="{070588D7-3A6D-EDDC-4D80-7A856315C37C}"/>
                </a:ext>
              </a:extLst>
            </p:cNvPr>
            <p:cNvSpPr/>
            <p:nvPr/>
          </p:nvSpPr>
          <p:spPr>
            <a:xfrm>
              <a:off x="4152271" y="8385087"/>
              <a:ext cx="360000" cy="21732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sz="11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ko-KR" altLang="en-US" sz="11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직사각형 24">
              <a:extLst>
                <a:ext uri="{FF2B5EF4-FFF2-40B4-BE49-F238E27FC236}">
                  <a16:creationId xmlns:a16="http://schemas.microsoft.com/office/drawing/2014/main" id="{06E85F00-F671-DDCA-2293-4626B5915B7F}"/>
                </a:ext>
              </a:extLst>
            </p:cNvPr>
            <p:cNvSpPr/>
            <p:nvPr/>
          </p:nvSpPr>
          <p:spPr>
            <a:xfrm>
              <a:off x="4764269" y="8385087"/>
              <a:ext cx="360000" cy="21732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sz="11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2</a:t>
              </a:r>
              <a:endParaRPr lang="ko-KR" altLang="en-US" sz="11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직사각형 25">
              <a:extLst>
                <a:ext uri="{FF2B5EF4-FFF2-40B4-BE49-F238E27FC236}">
                  <a16:creationId xmlns:a16="http://schemas.microsoft.com/office/drawing/2014/main" id="{FDCAB5D6-15AF-C5E1-BAD2-DEF73CB8C848}"/>
                </a:ext>
              </a:extLst>
            </p:cNvPr>
            <p:cNvSpPr/>
            <p:nvPr/>
          </p:nvSpPr>
          <p:spPr>
            <a:xfrm>
              <a:off x="5360192" y="8385087"/>
              <a:ext cx="360000" cy="21732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sz="11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4</a:t>
              </a:r>
              <a:endParaRPr lang="ko-KR" altLang="en-US" sz="11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9" name="직사각형 28">
            <a:extLst>
              <a:ext uri="{FF2B5EF4-FFF2-40B4-BE49-F238E27FC236}">
                <a16:creationId xmlns:a16="http://schemas.microsoft.com/office/drawing/2014/main" id="{1C1D8FAA-9758-8565-63BA-39367EA3859C}"/>
              </a:ext>
            </a:extLst>
          </p:cNvPr>
          <p:cNvSpPr/>
          <p:nvPr/>
        </p:nvSpPr>
        <p:spPr>
          <a:xfrm>
            <a:off x="538127" y="441810"/>
            <a:ext cx="513913" cy="21732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2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직사각형 29">
            <a:extLst>
              <a:ext uri="{FF2B5EF4-FFF2-40B4-BE49-F238E27FC236}">
                <a16:creationId xmlns:a16="http://schemas.microsoft.com/office/drawing/2014/main" id="{E129883D-D83F-1193-7AAB-56F9B7011DE3}"/>
              </a:ext>
            </a:extLst>
          </p:cNvPr>
          <p:cNvSpPr/>
          <p:nvPr/>
        </p:nvSpPr>
        <p:spPr>
          <a:xfrm>
            <a:off x="538126" y="4936742"/>
            <a:ext cx="513913" cy="21732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2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직사각형 3">
            <a:extLst>
              <a:ext uri="{FF2B5EF4-FFF2-40B4-BE49-F238E27FC236}">
                <a16:creationId xmlns:a16="http://schemas.microsoft.com/office/drawing/2014/main" id="{455BD81D-0649-262B-19DC-65FCA5D5EF56}"/>
              </a:ext>
            </a:extLst>
          </p:cNvPr>
          <p:cNvSpPr/>
          <p:nvPr/>
        </p:nvSpPr>
        <p:spPr>
          <a:xfrm>
            <a:off x="1854002" y="4521173"/>
            <a:ext cx="2679855" cy="28114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1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ime after transplantation</a:t>
            </a:r>
            <a:endParaRPr lang="ko-KR" altLang="en-US" sz="11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직사각형 4">
            <a:extLst>
              <a:ext uri="{FF2B5EF4-FFF2-40B4-BE49-F238E27FC236}">
                <a16:creationId xmlns:a16="http://schemas.microsoft.com/office/drawing/2014/main" id="{2D490CB3-F397-27E4-6B4B-60369726DDE4}"/>
              </a:ext>
            </a:extLst>
          </p:cNvPr>
          <p:cNvSpPr/>
          <p:nvPr/>
        </p:nvSpPr>
        <p:spPr>
          <a:xfrm>
            <a:off x="3747115" y="2445900"/>
            <a:ext cx="360000" cy="5005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sz="20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5215858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내용 개체 틀 4">
            <a:extLst>
              <a:ext uri="{FF2B5EF4-FFF2-40B4-BE49-F238E27FC236}">
                <a16:creationId xmlns:a16="http://schemas.microsoft.com/office/drawing/2014/main" id="{99E86762-582A-D31E-E140-0DFA1AC293B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91935839"/>
              </p:ext>
            </p:extLst>
          </p:nvPr>
        </p:nvGraphicFramePr>
        <p:xfrm>
          <a:off x="597717" y="694367"/>
          <a:ext cx="5978574" cy="8993124"/>
        </p:xfrm>
        <a:graphic>
          <a:graphicData uri="http://schemas.openxmlformats.org/drawingml/2006/table">
            <a:tbl>
              <a:tblPr firstRow="1" bandRow="1">
                <a:tableStyleId>{EB344D84-9AFB-497E-A393-DC336BA19D2E}</a:tableStyleId>
              </a:tblPr>
              <a:tblGrid>
                <a:gridCol w="2792029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265382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228436">
                  <a:extLst>
                    <a:ext uri="{9D8B030D-6E8A-4147-A177-3AD203B41FA5}">
                      <a16:colId xmlns:a16="http://schemas.microsoft.com/office/drawing/2014/main" val="1820569753"/>
                    </a:ext>
                  </a:extLst>
                </a:gridCol>
                <a:gridCol w="692727">
                  <a:extLst>
                    <a:ext uri="{9D8B030D-6E8A-4147-A177-3AD203B41FA5}">
                      <a16:colId xmlns:a16="http://schemas.microsoft.com/office/drawing/2014/main" val="3866734055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latinLnBrk="1">
                        <a:lnSpc>
                          <a:spcPct val="50000"/>
                        </a:lnSpc>
                      </a:pPr>
                      <a:endParaRPr lang="ko-KR" alt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9060" marR="99060" marT="49530" marB="4953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cluded  (N=680)</a:t>
                      </a:r>
                      <a:endParaRPr lang="ko-KR" altLang="en-US" sz="10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9060" marR="99060" marT="49530" marB="4953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cluded  (N=400)</a:t>
                      </a:r>
                      <a:endParaRPr lang="ko-KR" altLang="en-US" sz="10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9060" marR="99060" marT="49530" marB="4953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 value</a:t>
                      </a:r>
                      <a:endParaRPr lang="ko-KR" altLang="en-US" sz="1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9060" marR="99060" marT="49530" marB="4953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80104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1" hangingPunct="1">
                        <a:lnSpc>
                          <a:spcPct val="9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e (</a:t>
                      </a:r>
                      <a:r>
                        <a:rPr lang="en-US" altLang="ko-KR" sz="8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r</a:t>
                      </a: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, </a:t>
                      </a:r>
                      <a:r>
                        <a:rPr lang="en-US" altLang="ko-KR" sz="8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±SD</a:t>
                      </a: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9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6.1 ± 11.7</a:t>
                      </a: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9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.7±11.3</a:t>
                      </a: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90000"/>
                        </a:lnSpc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68</a:t>
                      </a: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9060" marR="99060" marT="49530" marB="49530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80104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1" hangingPunct="1">
                        <a:lnSpc>
                          <a:spcPct val="9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le</a:t>
                      </a:r>
                      <a:r>
                        <a:rPr lang="en-US" altLang="ko-KR" sz="8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g</a:t>
                      </a: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nder, n</a:t>
                      </a:r>
                      <a:r>
                        <a:rPr lang="ko-KR" altLang="en-US" sz="8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ko-KR" sz="8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%)</a:t>
                      </a: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9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19 (61.6%)</a:t>
                      </a: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9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7 (64.3%)</a:t>
                      </a: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9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428</a:t>
                      </a: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9060" marR="99060" marT="49530" marB="4953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73894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1" hangingPunct="1">
                        <a:lnSpc>
                          <a:spcPct val="9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MI (kg/m</a:t>
                      </a:r>
                      <a:r>
                        <a:rPr lang="en-US" altLang="ko-KR" sz="80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9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.9 ± 3.5</a:t>
                      </a: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9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.8 ± 3.4</a:t>
                      </a: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9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76</a:t>
                      </a: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7874915"/>
                  </a:ext>
                </a:extLst>
              </a:tr>
              <a:tr h="173894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1" hangingPunct="1">
                        <a:lnSpc>
                          <a:spcPct val="9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use</a:t>
                      </a:r>
                      <a:r>
                        <a:rPr lang="en-US" altLang="ko-KR" sz="8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of ESRD, n (%)</a:t>
                      </a: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indent="0" algn="ctr" latinLnBrk="1">
                        <a:lnSpc>
                          <a:spcPct val="90000"/>
                        </a:lnSpc>
                      </a:pP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indent="0" algn="ctr" latinLnBrk="1">
                        <a:lnSpc>
                          <a:spcPct val="90000"/>
                        </a:lnSpc>
                      </a:pP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indent="0" algn="ctr" latinLnBrk="1">
                        <a:lnSpc>
                          <a:spcPct val="90000"/>
                        </a:lnSpc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52</a:t>
                      </a: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80104">
                <a:tc>
                  <a:txBody>
                    <a:bodyPr/>
                    <a:lstStyle/>
                    <a:p>
                      <a:pPr marL="0" marR="0" indent="180000" algn="l" defTabSz="914400" rtl="0" eaLnBrk="1" fontAlgn="auto" latinLnBrk="1" hangingPunct="1">
                        <a:lnSpc>
                          <a:spcPct val="9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M</a:t>
                      </a: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9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5 (21.3%)</a:t>
                      </a:r>
                    </a:p>
                  </a:txBody>
                  <a:tcPr marL="99060" marR="99060" marT="49530" marB="4953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9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3 (18.3%)</a:t>
                      </a:r>
                    </a:p>
                  </a:txBody>
                  <a:tcPr marL="99060" marR="99060" marT="49530" marB="4953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9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ko-KR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80104">
                <a:tc>
                  <a:txBody>
                    <a:bodyPr/>
                    <a:lstStyle/>
                    <a:p>
                      <a:pPr marL="0" marR="0" indent="180000" algn="l" defTabSz="914400" rtl="0" eaLnBrk="1" fontAlgn="auto" latinLnBrk="1" hangingPunct="1">
                        <a:lnSpc>
                          <a:spcPct val="9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TN</a:t>
                      </a: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9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0 (26.5%)</a:t>
                      </a:r>
                    </a:p>
                  </a:txBody>
                  <a:tcPr marL="99060" marR="99060" marT="49530" marB="4953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9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4 (16.0%)</a:t>
                      </a:r>
                    </a:p>
                  </a:txBody>
                  <a:tcPr marL="99060" marR="99060" marT="49530" marB="4953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9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ko-KR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80104">
                <a:tc>
                  <a:txBody>
                    <a:bodyPr/>
                    <a:lstStyle/>
                    <a:p>
                      <a:pPr marL="0" marR="0" indent="180000" algn="l" defTabSz="914400" rtl="0" eaLnBrk="1" fontAlgn="auto" latinLnBrk="1" hangingPunct="1">
                        <a:lnSpc>
                          <a:spcPct val="9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N</a:t>
                      </a: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9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2 (31.2%)</a:t>
                      </a:r>
                    </a:p>
                  </a:txBody>
                  <a:tcPr marL="99060" marR="99060" marT="49530" marB="4953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9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2 (30.5%)</a:t>
                      </a:r>
                    </a:p>
                  </a:txBody>
                  <a:tcPr marL="99060" marR="99060" marT="49530" marB="4953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9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ko-KR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80104">
                <a:tc>
                  <a:txBody>
                    <a:bodyPr/>
                    <a:lstStyle/>
                    <a:p>
                      <a:pPr marL="0" marR="0" indent="180000" algn="l" defTabSz="914400" rtl="0" eaLnBrk="1" fontAlgn="auto" latinLnBrk="1" hangingPunct="1">
                        <a:lnSpc>
                          <a:spcPct val="9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PKD</a:t>
                      </a: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indent="0" algn="ctr" latinLnBrk="1">
                        <a:lnSpc>
                          <a:spcPct val="90000"/>
                        </a:lnSpc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 (4.6%)</a:t>
                      </a: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9060" marR="99060" marT="49530" marB="4953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indent="0" algn="ctr" latinLnBrk="1">
                        <a:lnSpc>
                          <a:spcPct val="90000"/>
                        </a:lnSpc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 (6.0%)</a:t>
                      </a: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9060" marR="99060" marT="49530" marB="4953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indent="0" algn="ctr" latinLnBrk="1">
                        <a:lnSpc>
                          <a:spcPct val="90000"/>
                        </a:lnSpc>
                      </a:pP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80104">
                <a:tc>
                  <a:txBody>
                    <a:bodyPr/>
                    <a:lstStyle/>
                    <a:p>
                      <a:pPr marL="0" marR="0" indent="180000" algn="l" defTabSz="914400" rtl="0" eaLnBrk="1" fontAlgn="auto" latinLnBrk="1" hangingPunct="1">
                        <a:lnSpc>
                          <a:spcPct val="9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thers</a:t>
                      </a: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indent="0" algn="ctr" latinLnBrk="1">
                        <a:lnSpc>
                          <a:spcPct val="90000"/>
                        </a:lnSpc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4 (5.0%)</a:t>
                      </a: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9060" marR="99060" marT="49530" marB="4953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indent="0" algn="ctr" latinLnBrk="1">
                        <a:lnSpc>
                          <a:spcPct val="90000"/>
                        </a:lnSpc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 (7.7%)</a:t>
                      </a: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9060" marR="99060" marT="49530" marB="4953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indent="0" algn="ctr" latinLnBrk="1">
                        <a:lnSpc>
                          <a:spcPct val="90000"/>
                        </a:lnSpc>
                      </a:pP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80104">
                <a:tc>
                  <a:txBody>
                    <a:bodyPr/>
                    <a:lstStyle/>
                    <a:p>
                      <a:pPr marL="0" marR="0" indent="180000" algn="l" defTabSz="914400" rtl="0" eaLnBrk="1" fontAlgn="auto" latinLnBrk="1" hangingPunct="1">
                        <a:lnSpc>
                          <a:spcPct val="9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nknown</a:t>
                      </a: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indent="0" algn="ctr" latinLnBrk="1">
                        <a:lnSpc>
                          <a:spcPct val="90000"/>
                        </a:lnSpc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8 (11.4%)</a:t>
                      </a: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9060" marR="99060" marT="49530" marB="4953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indent="0" algn="ctr" latinLnBrk="1">
                        <a:lnSpc>
                          <a:spcPct val="90000"/>
                        </a:lnSpc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6 (21.5%)</a:t>
                      </a: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9060" marR="99060" marT="49530" marB="4953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indent="0" algn="ctr" latinLnBrk="1">
                        <a:lnSpc>
                          <a:spcPct val="90000"/>
                        </a:lnSpc>
                      </a:pP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73894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1" hangingPunct="1">
                        <a:lnSpc>
                          <a:spcPct val="9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abetes mellitus, n (%)</a:t>
                      </a: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indent="0" algn="ctr" latinLnBrk="1">
                        <a:lnSpc>
                          <a:spcPct val="90000"/>
                        </a:lnSpc>
                      </a:pPr>
                      <a:r>
                        <a:rPr lang="en-US" altLang="ko-KR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2 (28.3%)</a:t>
                      </a:r>
                      <a:endParaRPr lang="ko-KR" alt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indent="0" algn="ctr" latinLnBrk="1">
                        <a:lnSpc>
                          <a:spcPct val="90000"/>
                        </a:lnSpc>
                      </a:pPr>
                      <a:r>
                        <a:rPr lang="en-US" altLang="ko-KR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3 (24.2%)</a:t>
                      </a:r>
                      <a:endParaRPr lang="ko-KR" alt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indent="0" algn="ctr" latinLnBrk="1">
                        <a:lnSpc>
                          <a:spcPct val="90000"/>
                        </a:lnSpc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62</a:t>
                      </a: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29373610"/>
                  </a:ext>
                </a:extLst>
              </a:tr>
              <a:tr h="173894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1" hangingPunct="1">
                        <a:lnSpc>
                          <a:spcPct val="9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ypertension , n (%)</a:t>
                      </a: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indent="0" algn="ctr" latinLnBrk="1">
                        <a:lnSpc>
                          <a:spcPct val="90000"/>
                        </a:lnSpc>
                      </a:pPr>
                      <a:r>
                        <a:rPr lang="en-US" altLang="ko-KR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51 (95.7%)</a:t>
                      </a:r>
                      <a:endParaRPr lang="ko-KR" alt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indent="0" algn="ctr" latinLnBrk="1">
                        <a:lnSpc>
                          <a:spcPct val="90000"/>
                        </a:lnSpc>
                      </a:pPr>
                      <a:r>
                        <a:rPr lang="en-US" altLang="ko-KR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83 (95.8%)</a:t>
                      </a:r>
                      <a:endParaRPr lang="ko-KR" alt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indent="0" algn="ctr" latinLnBrk="1">
                        <a:lnSpc>
                          <a:spcPct val="90000"/>
                        </a:lnSpc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96</a:t>
                      </a: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19871085"/>
                  </a:ext>
                </a:extLst>
              </a:tr>
              <a:tr h="173894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1" hangingPunct="1">
                        <a:lnSpc>
                          <a:spcPct val="9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rdiovascular disease, n (%)</a:t>
                      </a: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indent="0" algn="ctr" latinLnBrk="1">
                        <a:lnSpc>
                          <a:spcPct val="90000"/>
                        </a:lnSpc>
                      </a:pPr>
                      <a:r>
                        <a:rPr lang="en-US" altLang="ko-KR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9 (5.8%)</a:t>
                      </a:r>
                      <a:endParaRPr lang="ko-KR" alt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indent="0" algn="ctr" latinLnBrk="1">
                        <a:lnSpc>
                          <a:spcPct val="90000"/>
                        </a:lnSpc>
                      </a:pPr>
                      <a:r>
                        <a:rPr lang="en-US" altLang="ko-KR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 (7.6%)</a:t>
                      </a:r>
                      <a:endParaRPr lang="ko-KR" alt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indent="0" algn="ctr" latinLnBrk="1">
                        <a:lnSpc>
                          <a:spcPct val="90000"/>
                        </a:lnSpc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91</a:t>
                      </a: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8010639"/>
                  </a:ext>
                </a:extLst>
              </a:tr>
              <a:tr h="173894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1" hangingPunct="1">
                        <a:lnSpc>
                          <a:spcPct val="9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rebrovascular disease, n (%)</a:t>
                      </a: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indent="0" algn="ctr" latinLnBrk="1">
                        <a:lnSpc>
                          <a:spcPct val="90000"/>
                        </a:lnSpc>
                      </a:pPr>
                      <a:r>
                        <a:rPr lang="en-US" altLang="ko-KR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 (4.5%)</a:t>
                      </a:r>
                      <a:endParaRPr lang="ko-KR" alt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indent="0" algn="ctr" latinLnBrk="1">
                        <a:lnSpc>
                          <a:spcPct val="90000"/>
                        </a:lnSpc>
                      </a:pPr>
                      <a:r>
                        <a:rPr lang="en-US" altLang="ko-KR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 (3.1%)</a:t>
                      </a:r>
                      <a:endParaRPr lang="ko-KR" alt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indent="0" algn="ctr" latinLnBrk="1">
                        <a:lnSpc>
                          <a:spcPct val="90000"/>
                        </a:lnSpc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18</a:t>
                      </a: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83992374"/>
                  </a:ext>
                </a:extLst>
              </a:tr>
              <a:tr h="173894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1" hangingPunct="1">
                        <a:lnSpc>
                          <a:spcPct val="9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ype of RRT </a:t>
                      </a: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indent="0" algn="ctr" latinLnBrk="1">
                        <a:lnSpc>
                          <a:spcPct val="90000"/>
                        </a:lnSpc>
                      </a:pP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indent="0" algn="ctr" latinLnBrk="1">
                        <a:lnSpc>
                          <a:spcPct val="90000"/>
                        </a:lnSpc>
                      </a:pP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indent="0" algn="ctr" latinLnBrk="1">
                        <a:lnSpc>
                          <a:spcPct val="90000"/>
                        </a:lnSpc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9</a:t>
                      </a: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80104">
                <a:tc>
                  <a:txBody>
                    <a:bodyPr/>
                    <a:lstStyle/>
                    <a:p>
                      <a:pPr marL="0" marR="0" indent="180000" algn="l" defTabSz="914400" rtl="0" eaLnBrk="1" fontAlgn="auto" latinLnBrk="1" hangingPunct="1">
                        <a:lnSpc>
                          <a:spcPct val="9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D</a:t>
                      </a: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indent="0" algn="ctr" latinLnBrk="1">
                        <a:lnSpc>
                          <a:spcPct val="90000"/>
                        </a:lnSpc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22 (62.0%)</a:t>
                      </a: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9060" marR="99060" marT="49530" marB="4953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indent="0" algn="ctr" latinLnBrk="1">
                        <a:lnSpc>
                          <a:spcPct val="90000"/>
                        </a:lnSpc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8 (69.5%)</a:t>
                      </a: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9060" marR="99060" marT="49530" marB="4953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indent="0" algn="ctr" latinLnBrk="1">
                        <a:lnSpc>
                          <a:spcPct val="90000"/>
                        </a:lnSpc>
                      </a:pP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80104">
                <a:tc>
                  <a:txBody>
                    <a:bodyPr/>
                    <a:lstStyle/>
                    <a:p>
                      <a:pPr marL="0" marR="0" indent="180000" algn="l" defTabSz="914400" rtl="0" eaLnBrk="1" fontAlgn="auto" latinLnBrk="1" hangingPunct="1">
                        <a:lnSpc>
                          <a:spcPct val="9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D</a:t>
                      </a: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indent="0" algn="ctr" latinLnBrk="1">
                        <a:lnSpc>
                          <a:spcPct val="90000"/>
                        </a:lnSpc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2 (12.1%)</a:t>
                      </a: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9060" marR="99060" marT="49530" marB="4953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indent="0" algn="ctr" latinLnBrk="1">
                        <a:lnSpc>
                          <a:spcPct val="90000"/>
                        </a:lnSpc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4 (13.5%)</a:t>
                      </a: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9060" marR="99060" marT="49530" marB="4953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indent="0" algn="ctr" latinLnBrk="1">
                        <a:lnSpc>
                          <a:spcPct val="90000"/>
                        </a:lnSpc>
                      </a:pP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80104">
                <a:tc>
                  <a:txBody>
                    <a:bodyPr/>
                    <a:lstStyle/>
                    <a:p>
                      <a:pPr marL="0" marR="0" indent="180000" algn="l" defTabSz="914400" rtl="0" eaLnBrk="1" fontAlgn="auto" latinLnBrk="1" hangingPunct="1">
                        <a:lnSpc>
                          <a:spcPct val="9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eemptive</a:t>
                      </a: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indent="0" algn="ctr" latinLnBrk="1">
                        <a:lnSpc>
                          <a:spcPct val="90000"/>
                        </a:lnSpc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5 (24.3%)</a:t>
                      </a: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9060" marR="99060" marT="49530" marB="4953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indent="0" algn="ctr" latinLnBrk="1">
                        <a:lnSpc>
                          <a:spcPct val="90000"/>
                        </a:lnSpc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4 (16.0%)</a:t>
                      </a: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9060" marR="99060" marT="49530" marB="4953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indent="0" algn="ctr" latinLnBrk="1">
                        <a:lnSpc>
                          <a:spcPct val="90000"/>
                        </a:lnSpc>
                      </a:pP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180104">
                <a:tc>
                  <a:txBody>
                    <a:bodyPr/>
                    <a:lstStyle/>
                    <a:p>
                      <a:pPr marL="0" marR="0" indent="180000" algn="l" defTabSz="914400" rtl="0" eaLnBrk="1" fontAlgn="auto" latinLnBrk="1" hangingPunct="1">
                        <a:lnSpc>
                          <a:spcPct val="9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ansplantation</a:t>
                      </a:r>
                      <a:r>
                        <a:rPr lang="en-US" altLang="ko-KR" sz="8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indent="0" algn="ctr" latinLnBrk="1">
                        <a:lnSpc>
                          <a:spcPct val="90000"/>
                        </a:lnSpc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 (1.6%)</a:t>
                      </a: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9060" marR="99060" marT="49530" marB="4953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indent="0" algn="ctr" latinLnBrk="1">
                        <a:lnSpc>
                          <a:spcPct val="90000"/>
                        </a:lnSpc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 (1.0%)</a:t>
                      </a: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9060" marR="99060" marT="49530" marB="4953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indent="0" algn="ctr" latinLnBrk="1">
                        <a:lnSpc>
                          <a:spcPct val="90000"/>
                        </a:lnSpc>
                      </a:pP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173894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1" hangingPunct="1">
                        <a:lnSpc>
                          <a:spcPct val="9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me on dialysis prior</a:t>
                      </a:r>
                      <a:r>
                        <a:rPr lang="ko-KR" alt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 transplant (</a:t>
                      </a:r>
                      <a:r>
                        <a:rPr lang="en-US" altLang="ko-KR" sz="8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r</a:t>
                      </a: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, median (IQR)</a:t>
                      </a: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indent="0" algn="ctr" latinLnBrk="1">
                        <a:lnSpc>
                          <a:spcPct val="90000"/>
                        </a:lnSpc>
                      </a:pPr>
                      <a:r>
                        <a:rPr lang="en-US" altLang="ko-KR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 (0.1-2.4)</a:t>
                      </a:r>
                      <a:endParaRPr lang="ko-KR" alt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indent="0" algn="ctr" latinLnBrk="1">
                        <a:lnSpc>
                          <a:spcPct val="90000"/>
                        </a:lnSpc>
                      </a:pPr>
                      <a:r>
                        <a:rPr lang="en-US" altLang="ko-KR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 (0.1-3.7)</a:t>
                      </a:r>
                      <a:endParaRPr lang="ko-KR" alt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indent="0" algn="ctr" latinLnBrk="1">
                        <a:lnSpc>
                          <a:spcPct val="90000"/>
                        </a:lnSpc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92</a:t>
                      </a: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1786896"/>
                  </a:ext>
                </a:extLst>
              </a:tr>
              <a:tr h="173894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1" hangingPunct="1">
                        <a:lnSpc>
                          <a:spcPct val="9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nor source, n (%)</a:t>
                      </a: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indent="0" algn="ctr" latinLnBrk="1">
                        <a:lnSpc>
                          <a:spcPct val="90000"/>
                        </a:lnSpc>
                      </a:pP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indent="0" algn="ctr" latinLnBrk="1">
                        <a:lnSpc>
                          <a:spcPct val="90000"/>
                        </a:lnSpc>
                      </a:pP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9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31</a:t>
                      </a: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173894">
                <a:tc>
                  <a:txBody>
                    <a:bodyPr/>
                    <a:lstStyle/>
                    <a:p>
                      <a:pPr marL="0" marR="0" indent="180000" algn="l" defTabSz="914400" rtl="0" eaLnBrk="1" fontAlgn="auto" latinLnBrk="1" hangingPunct="1">
                        <a:lnSpc>
                          <a:spcPct val="9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ving</a:t>
                      </a: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9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70 (83.9%)</a:t>
                      </a: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9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2 (78.0%)</a:t>
                      </a: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9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173894">
                <a:tc>
                  <a:txBody>
                    <a:bodyPr/>
                    <a:lstStyle/>
                    <a:p>
                      <a:pPr marL="0" marR="0" indent="180000" algn="l" defTabSz="914400" rtl="0" eaLnBrk="1" fontAlgn="auto" latinLnBrk="1" hangingPunct="1">
                        <a:lnSpc>
                          <a:spcPct val="9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ceased</a:t>
                      </a: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9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0 (16.1%)</a:t>
                      </a: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9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8 (22.0%)</a:t>
                      </a: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9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01352752"/>
                  </a:ext>
                </a:extLst>
              </a:tr>
              <a:tr h="173894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1" hangingPunct="1">
                        <a:lnSpc>
                          <a:spcPct val="9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sensitization therapy, n (%)</a:t>
                      </a: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9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8 (27.7%)</a:t>
                      </a:r>
                      <a:endParaRPr lang="ko-KR" alt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9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3 (23.3%)</a:t>
                      </a:r>
                      <a:endParaRPr lang="ko-KR" alt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9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26</a:t>
                      </a: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56682375"/>
                  </a:ext>
                </a:extLst>
              </a:tr>
              <a:tr h="173894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1" hangingPunct="1">
                        <a:lnSpc>
                          <a:spcPct val="9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mmunosuppressant, n (%)</a:t>
                      </a: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indent="0" algn="ctr" latinLnBrk="1">
                        <a:lnSpc>
                          <a:spcPct val="90000"/>
                        </a:lnSpc>
                      </a:pP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indent="0" algn="ctr" latinLnBrk="1">
                        <a:lnSpc>
                          <a:spcPct val="90000"/>
                        </a:lnSpc>
                      </a:pP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indent="0" algn="ctr" latinLnBrk="1">
                        <a:lnSpc>
                          <a:spcPct val="90000"/>
                        </a:lnSpc>
                      </a:pP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173894">
                <a:tc>
                  <a:txBody>
                    <a:bodyPr/>
                    <a:lstStyle/>
                    <a:p>
                      <a:pPr marL="0" marR="0" indent="180000" algn="l" defTabSz="914400" rtl="0" eaLnBrk="1" fontAlgn="auto" latinLnBrk="1" hangingPunct="1">
                        <a:lnSpc>
                          <a:spcPct val="9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NI (</a:t>
                      </a:r>
                      <a:r>
                        <a:rPr lang="en-US" altLang="ko-KR" sz="8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crolimus</a:t>
                      </a: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indent="0" algn="ctr" latinLnBrk="1">
                        <a:lnSpc>
                          <a:spcPct val="90000"/>
                        </a:lnSpc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70 (98.5%)</a:t>
                      </a: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indent="0" algn="ctr" latinLnBrk="1">
                        <a:lnSpc>
                          <a:spcPct val="90000"/>
                        </a:lnSpc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91 (97.8%)</a:t>
                      </a: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indent="0" algn="ctr" latinLnBrk="1">
                        <a:lnSpc>
                          <a:spcPct val="90000"/>
                        </a:lnSpc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65</a:t>
                      </a: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173894">
                <a:tc>
                  <a:txBody>
                    <a:bodyPr/>
                    <a:lstStyle/>
                    <a:p>
                      <a:pPr marL="0" marR="0" indent="180000" algn="l" defTabSz="914400" rtl="0" eaLnBrk="1" fontAlgn="auto" latinLnBrk="1" hangingPunct="1">
                        <a:lnSpc>
                          <a:spcPct val="9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cophenolate </a:t>
                      </a:r>
                      <a:r>
                        <a:rPr lang="en-US" altLang="ko-KR" sz="800" baseline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fetile</a:t>
                      </a:r>
                      <a:endParaRPr lang="en-US" altLang="ko-KR" sz="8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9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94 (72.7%)</a:t>
                      </a: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9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7 (64.3%)</a:t>
                      </a: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9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4</a:t>
                      </a: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173894">
                <a:tc>
                  <a:txBody>
                    <a:bodyPr/>
                    <a:lstStyle/>
                    <a:p>
                      <a:pPr marL="0" marR="0" indent="180000" algn="l" defTabSz="914400" rtl="0" eaLnBrk="1" fontAlgn="auto" latinLnBrk="1" hangingPunct="1">
                        <a:lnSpc>
                          <a:spcPct val="9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baseline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cophenoleic</a:t>
                      </a:r>
                      <a:r>
                        <a:rPr lang="ko-KR" altLang="en-US" sz="8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ko-KR" sz="8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id</a:t>
                      </a: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9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5 (18.4%)</a:t>
                      </a: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9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8 (19.5%)</a:t>
                      </a: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9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75</a:t>
                      </a: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26620481"/>
                  </a:ext>
                </a:extLst>
              </a:tr>
              <a:tr h="173894">
                <a:tc>
                  <a:txBody>
                    <a:bodyPr/>
                    <a:lstStyle/>
                    <a:p>
                      <a:pPr marL="0" marR="0" lvl="0" indent="180000" algn="l" defTabSz="914400" rtl="0" eaLnBrk="1" fontAlgn="auto" latinLnBrk="1" hangingPunct="1">
                        <a:lnSpc>
                          <a:spcPct val="9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baseline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TOR</a:t>
                      </a:r>
                      <a:r>
                        <a:rPr lang="en-US" altLang="ko-KR" sz="8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inhibitors</a:t>
                      </a:r>
                      <a:r>
                        <a:rPr lang="ko-KR" altLang="en-US" sz="8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ko-KR" sz="8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US" altLang="ko-KR" sz="800" baseline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rolimus</a:t>
                      </a:r>
                      <a:r>
                        <a:rPr lang="en-US" altLang="ko-KR" sz="8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&amp; </a:t>
                      </a:r>
                      <a:r>
                        <a:rPr lang="en-US" altLang="ko-KR" sz="800" baseline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verolimus</a:t>
                      </a:r>
                      <a:r>
                        <a:rPr lang="en-US" altLang="ko-KR" sz="8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indent="0" algn="ctr" latinLnBrk="1">
                        <a:lnSpc>
                          <a:spcPct val="90000"/>
                        </a:lnSpc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8 (8.5%)</a:t>
                      </a: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indent="0" algn="ctr" latinLnBrk="1">
                        <a:lnSpc>
                          <a:spcPct val="90000"/>
                        </a:lnSpc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4 (16.0%)</a:t>
                      </a: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indent="0" algn="ctr" latinLnBrk="1">
                        <a:lnSpc>
                          <a:spcPct val="90000"/>
                        </a:lnSpc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24</a:t>
                      </a: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58281235"/>
                  </a:ext>
                </a:extLst>
              </a:tr>
              <a:tr h="173894">
                <a:tc>
                  <a:txBody>
                    <a:bodyPr/>
                    <a:lstStyle/>
                    <a:p>
                      <a:pPr marL="0" marR="0" lvl="0" indent="180000" algn="l" defTabSz="914400" rtl="0" eaLnBrk="1" fontAlgn="auto" latinLnBrk="1" hangingPunct="1">
                        <a:lnSpc>
                          <a:spcPct val="9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ednisolone </a:t>
                      </a: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indent="0" algn="ctr" latinLnBrk="1">
                        <a:lnSpc>
                          <a:spcPct val="90000"/>
                        </a:lnSpc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80 (100.0%)</a:t>
                      </a: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indent="0" algn="ctr" latinLnBrk="1">
                        <a:lnSpc>
                          <a:spcPct val="90000"/>
                        </a:lnSpc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0 (100.0%)</a:t>
                      </a: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indent="0" algn="ctr" latinLnBrk="1">
                        <a:lnSpc>
                          <a:spcPct val="90000"/>
                        </a:lnSpc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762867"/>
                  </a:ext>
                </a:extLst>
              </a:tr>
              <a:tr h="173894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1" hangingPunct="1">
                        <a:lnSpc>
                          <a:spcPct val="9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boratory findings </a:t>
                      </a: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indent="0" algn="ctr" latinLnBrk="1">
                        <a:lnSpc>
                          <a:spcPct val="90000"/>
                        </a:lnSpc>
                      </a:pP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indent="0" algn="ctr" latinLnBrk="1">
                        <a:lnSpc>
                          <a:spcPct val="90000"/>
                        </a:lnSpc>
                      </a:pP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indent="0" algn="ctr" latinLnBrk="1">
                        <a:lnSpc>
                          <a:spcPct val="90000"/>
                        </a:lnSpc>
                      </a:pP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13385585"/>
                  </a:ext>
                </a:extLst>
              </a:tr>
              <a:tr h="173894">
                <a:tc>
                  <a:txBody>
                    <a:bodyPr/>
                    <a:lstStyle/>
                    <a:p>
                      <a:pPr marL="0" marR="0" lvl="0" indent="180000" algn="l" defTabSz="914400" rtl="0" eaLnBrk="1" fontAlgn="auto" latinLnBrk="1" hangingPunct="1">
                        <a:lnSpc>
                          <a:spcPct val="9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rum creatinine (mg/dl), </a:t>
                      </a:r>
                      <a:r>
                        <a:rPr lang="en-US" altLang="ko-KR" sz="8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±SD</a:t>
                      </a:r>
                      <a:endParaRPr lang="en-US" altLang="ko-KR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indent="0" algn="ctr" latinLnBrk="1">
                        <a:lnSpc>
                          <a:spcPct val="90000"/>
                        </a:lnSpc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1 ± 0.64</a:t>
                      </a: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indent="0" algn="ctr" latinLnBrk="1">
                        <a:lnSpc>
                          <a:spcPct val="90000"/>
                        </a:lnSpc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4 ± 0.47</a:t>
                      </a: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indent="0" algn="ctr" latinLnBrk="1">
                        <a:lnSpc>
                          <a:spcPct val="90000"/>
                        </a:lnSpc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56</a:t>
                      </a: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73934985"/>
                  </a:ext>
                </a:extLst>
              </a:tr>
              <a:tr h="173894">
                <a:tc>
                  <a:txBody>
                    <a:bodyPr/>
                    <a:lstStyle/>
                    <a:p>
                      <a:pPr marL="0" marR="0" lvl="0" indent="180000" algn="l" defTabSz="914400" rtl="0" eaLnBrk="1" fontAlgn="auto" latinLnBrk="1" hangingPunct="1">
                        <a:lnSpc>
                          <a:spcPct val="9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GFR (ml/min/1.73 m</a:t>
                      </a:r>
                      <a:r>
                        <a:rPr lang="en-US" altLang="ko-KR" sz="80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, </a:t>
                      </a:r>
                      <a:r>
                        <a:rPr lang="en-US" altLang="ko-KR" sz="8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±SD</a:t>
                      </a: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indent="0" algn="ctr" latinLnBrk="1">
                        <a:lnSpc>
                          <a:spcPct val="90000"/>
                        </a:lnSpc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4.9 ± 22.1</a:t>
                      </a: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indent="0" algn="ctr" latinLnBrk="1">
                        <a:lnSpc>
                          <a:spcPct val="90000"/>
                        </a:lnSpc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3.7 ± 18.9</a:t>
                      </a: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indent="0" algn="ctr" latinLnBrk="1">
                        <a:lnSpc>
                          <a:spcPct val="90000"/>
                        </a:lnSpc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74</a:t>
                      </a: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15749440"/>
                  </a:ext>
                </a:extLst>
              </a:tr>
              <a:tr h="173894">
                <a:tc>
                  <a:txBody>
                    <a:bodyPr/>
                    <a:lstStyle/>
                    <a:p>
                      <a:pPr marL="0" marR="0" lvl="0" indent="180000" algn="l" defTabSz="914400" rtl="0" eaLnBrk="1" fontAlgn="auto" latinLnBrk="1" hangingPunct="1">
                        <a:lnSpc>
                          <a:spcPct val="9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bumin (g/dL), </a:t>
                      </a:r>
                      <a:r>
                        <a:rPr lang="en-US" altLang="ko-KR" sz="8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±SD</a:t>
                      </a: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indent="0" algn="ctr" latinLnBrk="1">
                        <a:lnSpc>
                          <a:spcPct val="90000"/>
                        </a:lnSpc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0 ± 0.5</a:t>
                      </a: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indent="0" algn="ctr" latinLnBrk="1">
                        <a:lnSpc>
                          <a:spcPct val="90000"/>
                        </a:lnSpc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0 ± 0.5</a:t>
                      </a: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indent="0" algn="ctr" latinLnBrk="1">
                        <a:lnSpc>
                          <a:spcPct val="90000"/>
                        </a:lnSpc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84</a:t>
                      </a: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97228505"/>
                  </a:ext>
                </a:extLst>
              </a:tr>
              <a:tr h="173894">
                <a:tc>
                  <a:txBody>
                    <a:bodyPr/>
                    <a:lstStyle/>
                    <a:p>
                      <a:pPr marL="0" marR="0" indent="180000" algn="l" defTabSz="914400" rtl="0" eaLnBrk="1" fontAlgn="auto" latinLnBrk="1" hangingPunct="1">
                        <a:lnSpc>
                          <a:spcPct val="9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moglobin  (g/dL), </a:t>
                      </a:r>
                      <a:r>
                        <a:rPr lang="en-US" altLang="ko-KR" sz="8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±SD</a:t>
                      </a:r>
                      <a:endParaRPr lang="en-US" altLang="ko-KR" sz="8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9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5 ± 1.6</a:t>
                      </a: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9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5 ± 1.6</a:t>
                      </a: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9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98</a:t>
                      </a: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86241627"/>
                  </a:ext>
                </a:extLst>
              </a:tr>
              <a:tr h="173894">
                <a:tc>
                  <a:txBody>
                    <a:bodyPr/>
                    <a:lstStyle/>
                    <a:p>
                      <a:pPr marL="0" marR="0" lvl="0" indent="180000" algn="l" defTabSz="914400" rtl="0" eaLnBrk="1" fontAlgn="auto" latinLnBrk="1" hangingPunct="1">
                        <a:lnSpc>
                          <a:spcPct val="9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-reactive protein (mg/dL), </a:t>
                      </a: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 (IQR)</a:t>
                      </a:r>
                      <a:endParaRPr lang="ko-KR" alt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9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8 (0.03-0.27)</a:t>
                      </a:r>
                      <a:endParaRPr lang="ko-KR" alt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9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9 (0.04-0.30)</a:t>
                      </a:r>
                      <a:endParaRPr lang="ko-KR" alt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9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78</a:t>
                      </a: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07541718"/>
                  </a:ext>
                </a:extLst>
              </a:tr>
              <a:tr h="173894">
                <a:tc>
                  <a:txBody>
                    <a:bodyPr/>
                    <a:lstStyle/>
                    <a:p>
                      <a:pPr marL="0" marR="0" lvl="0" indent="180000" algn="l" defTabSz="914400" rtl="0" eaLnBrk="1" fontAlgn="auto" latinLnBrk="1" hangingPunct="1">
                        <a:lnSpc>
                          <a:spcPct val="9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 cholesterol (mg/dL), </a:t>
                      </a:r>
                      <a:r>
                        <a:rPr lang="en-US" altLang="ko-KR" sz="8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±SD</a:t>
                      </a: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ko-KR" alt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9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3.2 ± 42.7</a:t>
                      </a: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9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6.7 ± 39.0</a:t>
                      </a: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9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83</a:t>
                      </a: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41804852"/>
                  </a:ext>
                </a:extLst>
              </a:tr>
              <a:tr h="173894">
                <a:tc>
                  <a:txBody>
                    <a:bodyPr/>
                    <a:lstStyle/>
                    <a:p>
                      <a:pPr marL="0" marR="0" lvl="0" indent="180000" algn="l" defTabSz="914400" rtl="0" eaLnBrk="1" fontAlgn="auto" latinLnBrk="1" hangingPunct="1">
                        <a:lnSpc>
                          <a:spcPct val="9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iglyceride (mg/dL), </a:t>
                      </a:r>
                      <a:r>
                        <a:rPr lang="en-US" altLang="ko-KR" sz="8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±SD</a:t>
                      </a: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ko-KR" alt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9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6.6 ± 83.0</a:t>
                      </a: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9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5.2 ± 87.0</a:t>
                      </a: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9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90</a:t>
                      </a: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65351443"/>
                  </a:ext>
                </a:extLst>
              </a:tr>
              <a:tr h="173894">
                <a:tc>
                  <a:txBody>
                    <a:bodyPr/>
                    <a:lstStyle/>
                    <a:p>
                      <a:pPr marL="0" marR="0" lvl="0" indent="180000" algn="l" defTabSz="914400" rtl="0" eaLnBrk="1" fontAlgn="auto" latinLnBrk="1" hangingPunct="1">
                        <a:lnSpc>
                          <a:spcPct val="9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DL cholesterol (mg/dL), </a:t>
                      </a:r>
                      <a:r>
                        <a:rPr lang="en-US" altLang="ko-KR" sz="80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</a:t>
                      </a:r>
                      <a:r>
                        <a:rPr lang="en-US" altLang="ko-KR" sz="8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SD</a:t>
                      </a: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ko-KR" alt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9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2.8 ± 30.5</a:t>
                      </a: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9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3.8 ± 29.6</a:t>
                      </a: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9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68</a:t>
                      </a: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5514877"/>
                  </a:ext>
                </a:extLst>
              </a:tr>
              <a:tr h="173894">
                <a:tc>
                  <a:txBody>
                    <a:bodyPr/>
                    <a:lstStyle/>
                    <a:p>
                      <a:pPr marL="0" marR="0" lvl="0" indent="180000" algn="l" defTabSz="914400" rtl="0" eaLnBrk="1" fontAlgn="auto" latinLnBrk="1" hangingPunct="1">
                        <a:lnSpc>
                          <a:spcPct val="9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lcium (mg/dL), </a:t>
                      </a:r>
                      <a:r>
                        <a:rPr lang="en-US" altLang="ko-KR" sz="8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±SD</a:t>
                      </a: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ko-KR" alt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9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8 ± 0.9 </a:t>
                      </a: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8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8 ± 0.9 </a:t>
                      </a: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9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53</a:t>
                      </a: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51398620"/>
                  </a:ext>
                </a:extLst>
              </a:tr>
              <a:tr h="173894">
                <a:tc>
                  <a:txBody>
                    <a:bodyPr/>
                    <a:lstStyle/>
                    <a:p>
                      <a:pPr marL="0" marR="0" lvl="0" indent="180000" algn="l" defTabSz="914400" rtl="0" eaLnBrk="1" fontAlgn="auto" latinLnBrk="1" hangingPunct="1">
                        <a:lnSpc>
                          <a:spcPct val="9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hosphorus (mg/dL),</a:t>
                      </a: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ko-KR" sz="8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±SD</a:t>
                      </a: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ko-KR" alt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9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0 ± 1.5</a:t>
                      </a: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8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2 ± 1.4</a:t>
                      </a: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9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70</a:t>
                      </a: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17774262"/>
                  </a:ext>
                </a:extLst>
              </a:tr>
              <a:tr h="173894">
                <a:tc>
                  <a:txBody>
                    <a:bodyPr/>
                    <a:lstStyle/>
                    <a:p>
                      <a:pPr marL="0" marR="0" lvl="0" indent="180000" algn="l" defTabSz="914400" rtl="0" eaLnBrk="1" fontAlgn="auto" latinLnBrk="1" hangingPunct="1">
                        <a:lnSpc>
                          <a:spcPct val="9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TH (</a:t>
                      </a:r>
                      <a:r>
                        <a:rPr lang="en-US" altLang="ko-KR" sz="80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g</a:t>
                      </a:r>
                      <a:r>
                        <a:rPr lang="en-US" altLang="ko-KR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mL), median (IQR)</a:t>
                      </a:r>
                      <a:endParaRPr lang="ko-KR" alt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9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2.0 (111.5-346.9) </a:t>
                      </a: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8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5.0 (118.5-351.0)</a:t>
                      </a: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9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60</a:t>
                      </a: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37601666"/>
                  </a:ext>
                </a:extLst>
              </a:tr>
              <a:tr h="173894">
                <a:tc>
                  <a:txBody>
                    <a:bodyPr/>
                    <a:lstStyle/>
                    <a:p>
                      <a:pPr marL="0" marR="0" indent="180000" algn="l" defTabSz="914400" rtl="0" eaLnBrk="1" fontAlgn="auto" latinLnBrk="1" hangingPunct="1">
                        <a:lnSpc>
                          <a:spcPct val="9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(OH)D (ng/ml), </a:t>
                      </a:r>
                      <a:r>
                        <a:rPr lang="en-US" altLang="ko-KR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 (IQR)</a:t>
                      </a:r>
                      <a:endParaRPr lang="en-US" altLang="ko-KR" sz="8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9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.2 (7.4-16.7)</a:t>
                      </a:r>
                      <a:endParaRPr lang="ko-KR" alt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9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.3 (7.1-17.0)</a:t>
                      </a:r>
                      <a:endParaRPr lang="ko-KR" alt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9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13</a:t>
                      </a:r>
                      <a:endParaRPr lang="ko-KR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29648428"/>
                  </a:ext>
                </a:extLst>
              </a:tr>
            </a:tbl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2B1FDDA9-A202-0EE8-E800-DA01BA6291AD}"/>
              </a:ext>
            </a:extLst>
          </p:cNvPr>
          <p:cNvSpPr txBox="1"/>
          <p:nvPr/>
        </p:nvSpPr>
        <p:spPr>
          <a:xfrm>
            <a:off x="96404" y="59087"/>
            <a:ext cx="6665191" cy="51520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20000"/>
              </a:lnSpc>
            </a:pP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</a:t>
            </a:r>
          </a:p>
          <a:p>
            <a:pPr>
              <a:lnSpc>
                <a:spcPct val="120000"/>
              </a:lnSpc>
            </a:pP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Table S1.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Comparisons of baseline characteristics of patients included and excluded in analysis</a:t>
            </a:r>
          </a:p>
        </p:txBody>
      </p:sp>
    </p:spTree>
    <p:extLst>
      <p:ext uri="{BB962C8B-B14F-4D97-AF65-F5344CB8AC3E}">
        <p14:creationId xmlns:p14="http://schemas.microsoft.com/office/powerpoint/2010/main" val="42572400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0409</TotalTime>
  <Words>668</Words>
  <Application>Microsoft Office PowerPoint</Application>
  <PresentationFormat>A4 용지(210x297mm)</PresentationFormat>
  <Paragraphs>177</Paragraphs>
  <Slides>2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2</vt:i4>
      </vt:variant>
    </vt:vector>
  </HeadingPairs>
  <TitlesOfParts>
    <vt:vector size="7" baseType="lpstr">
      <vt:lpstr>맑은 고딕</vt:lpstr>
      <vt:lpstr>Arial</vt:lpstr>
      <vt:lpstr>Calibri</vt:lpstr>
      <vt:lpstr>Calibri Light</vt:lpstr>
      <vt:lpstr>Office 테마</vt:lpstr>
      <vt:lpstr>Supplemental Figure S1. Post-transplant changes in FGF-23 levels. (a) FGF23 level in 3 years was decreased after kidney transplantation compared to FGF23 at baseline (*P=0.001). (b) Positive correlation in FGF23 levels between  baseline and 3 years after transplantation was observed (γ2=0.095, P=0.001).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JungHwa</dc:creator>
  <cp:lastModifiedBy>hachangyoon</cp:lastModifiedBy>
  <cp:revision>231</cp:revision>
  <dcterms:created xsi:type="dcterms:W3CDTF">2018-02-24T13:50:33Z</dcterms:created>
  <dcterms:modified xsi:type="dcterms:W3CDTF">2023-10-10T03:32:53Z</dcterms:modified>
</cp:coreProperties>
</file>